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56" r:id="rId2"/>
    <p:sldId id="259" r:id="rId3"/>
    <p:sldId id="264" r:id="rId4"/>
    <p:sldId id="263" r:id="rId5"/>
    <p:sldId id="266" r:id="rId6"/>
    <p:sldId id="265" r:id="rId7"/>
    <p:sldId id="257" r:id="rId8"/>
    <p:sldId id="260" r:id="rId9"/>
    <p:sldId id="262" r:id="rId10"/>
  </p:sldIdLst>
  <p:sldSz cx="7559675" cy="1058386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3597" autoAdjust="0"/>
  </p:normalViewPr>
  <p:slideViewPr>
    <p:cSldViewPr snapToGrid="0">
      <p:cViewPr varScale="1">
        <p:scale>
          <a:sx n="75" d="100"/>
          <a:sy n="75" d="100"/>
        </p:scale>
        <p:origin x="333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30284" y="0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F2CD20-3E33-4801-8E1D-3C175A573AA4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49725" y="850900"/>
            <a:ext cx="16398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4399" y="3275850"/>
            <a:ext cx="7950543" cy="268004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465807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30284" y="6465807"/>
            <a:ext cx="4306737" cy="3413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48F091-E8D0-4252-A58F-5DD0E363DC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73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32129"/>
            <a:ext cx="6425724" cy="3684752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558979"/>
            <a:ext cx="5669756" cy="2555316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840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161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3493"/>
            <a:ext cx="1630055" cy="896933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3493"/>
            <a:ext cx="4795669" cy="896933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354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153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38619"/>
            <a:ext cx="6520220" cy="4402592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082862"/>
            <a:ext cx="6520220" cy="2315219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298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17463"/>
            <a:ext cx="3212862" cy="67153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17463"/>
            <a:ext cx="3212862" cy="67153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877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3495"/>
            <a:ext cx="6520220" cy="204572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94517"/>
            <a:ext cx="3198096" cy="1271533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66050"/>
            <a:ext cx="3198096" cy="56863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94517"/>
            <a:ext cx="3213847" cy="1271533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66050"/>
            <a:ext cx="3213847" cy="56863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251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2054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84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05591"/>
            <a:ext cx="2438192" cy="246956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23882"/>
            <a:ext cx="3827085" cy="7521403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75159"/>
            <a:ext cx="2438192" cy="5882375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280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05591"/>
            <a:ext cx="2438192" cy="246956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23882"/>
            <a:ext cx="3827085" cy="7521403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75159"/>
            <a:ext cx="2438192" cy="5882375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8734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3495"/>
            <a:ext cx="6520220" cy="20457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17463"/>
            <a:ext cx="6520220" cy="67153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809675"/>
            <a:ext cx="1700927" cy="563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7E632-9DE5-414D-A688-7DC384AFF226}" type="datetimeFigureOut">
              <a:rPr kumimoji="1" lang="ja-JP" altLang="en-US" smtClean="0"/>
              <a:t>2026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809675"/>
            <a:ext cx="2551390" cy="563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809675"/>
            <a:ext cx="1700927" cy="563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AE34F-EDB1-4EB3-B972-A42F22581B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260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ti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g"/><Relationship Id="rId3" Type="http://schemas.microsoft.com/office/2007/relationships/hdphoto" Target="../media/hdphoto1.wdp"/><Relationship Id="rId7" Type="http://schemas.openxmlformats.org/officeDocument/2006/relationships/image" Target="../media/image21.jp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g"/><Relationship Id="rId5" Type="http://schemas.microsoft.com/office/2007/relationships/hdphoto" Target="../media/hdphoto2.wdp"/><Relationship Id="rId4" Type="http://schemas.openxmlformats.org/officeDocument/2006/relationships/image" Target="../media/image19.png"/><Relationship Id="rId9" Type="http://schemas.openxmlformats.org/officeDocument/2006/relationships/image" Target="../media/image2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jpg"/><Relationship Id="rId4" Type="http://schemas.microsoft.com/office/2007/relationships/hdphoto" Target="../media/hdphoto3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jpg"/><Relationship Id="rId7" Type="http://schemas.openxmlformats.org/officeDocument/2006/relationships/image" Target="../media/image34.png"/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jpg"/><Relationship Id="rId5" Type="http://schemas.openxmlformats.org/officeDocument/2006/relationships/image" Target="../media/image32.jpg"/><Relationship Id="rId10" Type="http://schemas.openxmlformats.org/officeDocument/2006/relationships/image" Target="../media/image37.png"/><Relationship Id="rId4" Type="http://schemas.openxmlformats.org/officeDocument/2006/relationships/image" Target="../media/image31.jp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>
            <a:extLst>
              <a:ext uri="{FF2B5EF4-FFF2-40B4-BE49-F238E27FC236}">
                <a16:creationId xmlns:a16="http://schemas.microsoft.com/office/drawing/2014/main" id="{A8CBB1BD-73E4-A1C5-0EA1-EE6FD93F05C9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541" y="1656640"/>
            <a:ext cx="3003556" cy="4124884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6497A09-E4C2-C85C-8E0D-94DE0F24A76C}"/>
              </a:ext>
            </a:extLst>
          </p:cNvPr>
          <p:cNvSpPr/>
          <p:nvPr/>
        </p:nvSpPr>
        <p:spPr>
          <a:xfrm>
            <a:off x="1450817" y="3718087"/>
            <a:ext cx="173467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10359B3-C7F6-34E0-82DD-FC5B56A89336}"/>
              </a:ext>
            </a:extLst>
          </p:cNvPr>
          <p:cNvSpPr txBox="1"/>
          <p:nvPr/>
        </p:nvSpPr>
        <p:spPr>
          <a:xfrm>
            <a:off x="754725" y="353345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E0B7987-47D6-4C18-0558-5D183ADA76CD}"/>
              </a:ext>
            </a:extLst>
          </p:cNvPr>
          <p:cNvSpPr txBox="1"/>
          <p:nvPr/>
        </p:nvSpPr>
        <p:spPr>
          <a:xfrm>
            <a:off x="754859" y="376774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4256B42-B775-F317-4CB8-5DE160433745}"/>
              </a:ext>
            </a:extLst>
          </p:cNvPr>
          <p:cNvSpPr txBox="1"/>
          <p:nvPr/>
        </p:nvSpPr>
        <p:spPr>
          <a:xfrm rot="18243495">
            <a:off x="1371271" y="327474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8212E91-71B3-7F35-7B1C-67521A48C4EC}"/>
              </a:ext>
            </a:extLst>
          </p:cNvPr>
          <p:cNvSpPr txBox="1"/>
          <p:nvPr/>
        </p:nvSpPr>
        <p:spPr>
          <a:xfrm rot="18243495">
            <a:off x="1578133" y="327607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2B0F821-E8BA-6020-4BBE-44AE9D4D5DC5}"/>
              </a:ext>
            </a:extLst>
          </p:cNvPr>
          <p:cNvSpPr txBox="1"/>
          <p:nvPr/>
        </p:nvSpPr>
        <p:spPr>
          <a:xfrm rot="18243495">
            <a:off x="1719132" y="3173118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217EC99-C5A5-9513-0857-32B092D738C5}"/>
              </a:ext>
            </a:extLst>
          </p:cNvPr>
          <p:cNvSpPr txBox="1"/>
          <p:nvPr/>
        </p:nvSpPr>
        <p:spPr>
          <a:xfrm rot="18243495">
            <a:off x="1915661" y="317444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91E3F8C-4889-6AA2-521D-04D8AEE54B11}"/>
              </a:ext>
            </a:extLst>
          </p:cNvPr>
          <p:cNvSpPr txBox="1"/>
          <p:nvPr/>
        </p:nvSpPr>
        <p:spPr>
          <a:xfrm rot="18243495">
            <a:off x="2126108" y="3175768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66995E4-A4E6-9601-14FB-2A01A356901A}"/>
              </a:ext>
            </a:extLst>
          </p:cNvPr>
          <p:cNvSpPr txBox="1"/>
          <p:nvPr/>
        </p:nvSpPr>
        <p:spPr>
          <a:xfrm rot="18243495">
            <a:off x="2340790" y="3175768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63FC96A-4D10-E37D-A336-4B86986015B8}"/>
              </a:ext>
            </a:extLst>
          </p:cNvPr>
          <p:cNvSpPr txBox="1"/>
          <p:nvPr/>
        </p:nvSpPr>
        <p:spPr>
          <a:xfrm rot="18243495">
            <a:off x="2546462" y="3177093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CCD997E-129B-F52C-AD71-A8F230522753}"/>
              </a:ext>
            </a:extLst>
          </p:cNvPr>
          <p:cNvSpPr txBox="1"/>
          <p:nvPr/>
        </p:nvSpPr>
        <p:spPr>
          <a:xfrm rot="18243495">
            <a:off x="2730668" y="3186371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7103016-1894-96C7-0278-4878D5DB6942}"/>
              </a:ext>
            </a:extLst>
          </p:cNvPr>
          <p:cNvSpPr txBox="1"/>
          <p:nvPr/>
        </p:nvSpPr>
        <p:spPr>
          <a:xfrm>
            <a:off x="738910" y="169970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8E09C986-9CE7-6ABF-0C2B-3D4DF597E7C0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0217" y="1658227"/>
            <a:ext cx="3002400" cy="4123297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35C3BA3-E181-E8AA-15EF-C551B0045E21}"/>
              </a:ext>
            </a:extLst>
          </p:cNvPr>
          <p:cNvSpPr/>
          <p:nvPr/>
        </p:nvSpPr>
        <p:spPr>
          <a:xfrm>
            <a:off x="4712140" y="3750786"/>
            <a:ext cx="1569492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F38FC32-A658-7BFE-B246-62DC79A5ECD6}"/>
              </a:ext>
            </a:extLst>
          </p:cNvPr>
          <p:cNvSpPr txBox="1"/>
          <p:nvPr/>
        </p:nvSpPr>
        <p:spPr>
          <a:xfrm>
            <a:off x="4054210" y="360457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596BC2B-A29E-B105-175A-97BAB6C47452}"/>
              </a:ext>
            </a:extLst>
          </p:cNvPr>
          <p:cNvSpPr txBox="1"/>
          <p:nvPr/>
        </p:nvSpPr>
        <p:spPr>
          <a:xfrm>
            <a:off x="4063488" y="3820581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EF60C2B-F185-C74B-0AF5-0124C7A3730B}"/>
              </a:ext>
            </a:extLst>
          </p:cNvPr>
          <p:cNvSpPr txBox="1"/>
          <p:nvPr/>
        </p:nvSpPr>
        <p:spPr>
          <a:xfrm rot="18243495">
            <a:off x="4607831" y="333715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3C2C360-E0C4-765A-EF57-25B18FCFCCAF}"/>
              </a:ext>
            </a:extLst>
          </p:cNvPr>
          <p:cNvSpPr txBox="1"/>
          <p:nvPr/>
        </p:nvSpPr>
        <p:spPr>
          <a:xfrm rot="18243495">
            <a:off x="4795549" y="330018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CDA610A-11FD-EDA8-E21C-9B7D3E6433BD}"/>
              </a:ext>
            </a:extLst>
          </p:cNvPr>
          <p:cNvSpPr txBox="1"/>
          <p:nvPr/>
        </p:nvSpPr>
        <p:spPr>
          <a:xfrm rot="18243495">
            <a:off x="5019508" y="3293560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VP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1AC8624-E266-70AE-81E7-BD6103F7FCCA}"/>
              </a:ext>
            </a:extLst>
          </p:cNvPr>
          <p:cNvSpPr txBox="1"/>
          <p:nvPr/>
        </p:nvSpPr>
        <p:spPr>
          <a:xfrm rot="18243495">
            <a:off x="5251419" y="329488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95070BB-02D0-E31E-28F6-314F67EA989F}"/>
              </a:ext>
            </a:extLst>
          </p:cNvPr>
          <p:cNvSpPr txBox="1"/>
          <p:nvPr/>
        </p:nvSpPr>
        <p:spPr>
          <a:xfrm rot="18243495">
            <a:off x="5475380" y="3296211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0890F90-12D3-EFF5-31B4-E3FF78D653F0}"/>
              </a:ext>
            </a:extLst>
          </p:cNvPr>
          <p:cNvSpPr txBox="1"/>
          <p:nvPr/>
        </p:nvSpPr>
        <p:spPr>
          <a:xfrm rot="18243495">
            <a:off x="5691389" y="3297536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D189B67-A0EC-205B-16B0-FD13B0587A8B}"/>
              </a:ext>
            </a:extLst>
          </p:cNvPr>
          <p:cNvSpPr txBox="1"/>
          <p:nvPr/>
        </p:nvSpPr>
        <p:spPr>
          <a:xfrm rot="18243495">
            <a:off x="5899448" y="3298862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CCBE72F-4A9B-29AE-7BFC-252C753982AD}"/>
              </a:ext>
            </a:extLst>
          </p:cNvPr>
          <p:cNvSpPr txBox="1"/>
          <p:nvPr/>
        </p:nvSpPr>
        <p:spPr>
          <a:xfrm>
            <a:off x="3908079" y="1709243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1ECF2D3-81C8-D960-FA26-97F163F2D651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083" y="5865171"/>
            <a:ext cx="3002400" cy="4123297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33943A6-1EDC-CF99-988D-2456E67ED269}"/>
              </a:ext>
            </a:extLst>
          </p:cNvPr>
          <p:cNvSpPr/>
          <p:nvPr/>
        </p:nvSpPr>
        <p:spPr>
          <a:xfrm>
            <a:off x="1439457" y="7750455"/>
            <a:ext cx="173467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11AD703-E04E-48AE-24D9-1C1D805CF482}"/>
              </a:ext>
            </a:extLst>
          </p:cNvPr>
          <p:cNvSpPr txBox="1"/>
          <p:nvPr/>
        </p:nvSpPr>
        <p:spPr>
          <a:xfrm>
            <a:off x="801506" y="765110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D172471-C455-F0B2-D45B-CF74D26E8C9A}"/>
              </a:ext>
            </a:extLst>
          </p:cNvPr>
          <p:cNvSpPr txBox="1"/>
          <p:nvPr/>
        </p:nvSpPr>
        <p:spPr>
          <a:xfrm>
            <a:off x="810784" y="786711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7274DEB-64E9-E63F-B943-F7D7DDA1E3B2}"/>
              </a:ext>
            </a:extLst>
          </p:cNvPr>
          <p:cNvSpPr txBox="1"/>
          <p:nvPr/>
        </p:nvSpPr>
        <p:spPr>
          <a:xfrm rot="18243495">
            <a:off x="1361762" y="732138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228C7F2-EADA-5193-B596-275FE10D9D23}"/>
              </a:ext>
            </a:extLst>
          </p:cNvPr>
          <p:cNvSpPr txBox="1"/>
          <p:nvPr/>
        </p:nvSpPr>
        <p:spPr>
          <a:xfrm rot="18243495">
            <a:off x="1569817" y="732270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054CEB-3287-D8FE-06C6-BE71E08165CA}"/>
              </a:ext>
            </a:extLst>
          </p:cNvPr>
          <p:cNvSpPr txBox="1"/>
          <p:nvPr/>
        </p:nvSpPr>
        <p:spPr>
          <a:xfrm rot="18243495">
            <a:off x="1718767" y="7219751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3FB97B1-AD2F-E698-4B13-33D9B20303B7}"/>
              </a:ext>
            </a:extLst>
          </p:cNvPr>
          <p:cNvSpPr txBox="1"/>
          <p:nvPr/>
        </p:nvSpPr>
        <p:spPr>
          <a:xfrm rot="18243495">
            <a:off x="1934777" y="7221077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380E7D4-C368-68FC-0493-33EF8379103E}"/>
              </a:ext>
            </a:extLst>
          </p:cNvPr>
          <p:cNvSpPr txBox="1"/>
          <p:nvPr/>
        </p:nvSpPr>
        <p:spPr>
          <a:xfrm rot="18243495">
            <a:off x="2134887" y="7222401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135C85B-655D-C5A8-7D86-8DAB9338D826}"/>
              </a:ext>
            </a:extLst>
          </p:cNvPr>
          <p:cNvSpPr txBox="1"/>
          <p:nvPr/>
        </p:nvSpPr>
        <p:spPr>
          <a:xfrm rot="18243495">
            <a:off x="2349569" y="7222401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7D44C86-504C-D262-C6A3-B789DF46D9D8}"/>
              </a:ext>
            </a:extLst>
          </p:cNvPr>
          <p:cNvSpPr txBox="1"/>
          <p:nvPr/>
        </p:nvSpPr>
        <p:spPr>
          <a:xfrm rot="18243495">
            <a:off x="2557627" y="7223726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367F2B1-517C-991E-F56D-FAED36C9A678}"/>
              </a:ext>
            </a:extLst>
          </p:cNvPr>
          <p:cNvSpPr txBox="1"/>
          <p:nvPr/>
        </p:nvSpPr>
        <p:spPr>
          <a:xfrm rot="18243495">
            <a:off x="2757735" y="723300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2693B4E-D831-D878-3497-8F946C140CBB}"/>
              </a:ext>
            </a:extLst>
          </p:cNvPr>
          <p:cNvSpPr txBox="1"/>
          <p:nvPr/>
        </p:nvSpPr>
        <p:spPr>
          <a:xfrm>
            <a:off x="743882" y="5896801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43C9B2BE-4305-7955-930D-70031095CF72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9426" y="5862275"/>
            <a:ext cx="3002400" cy="4123297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9213DB0D-78F6-D377-0AD7-0506EEB6F80E}"/>
              </a:ext>
            </a:extLst>
          </p:cNvPr>
          <p:cNvSpPr/>
          <p:nvPr/>
        </p:nvSpPr>
        <p:spPr>
          <a:xfrm>
            <a:off x="4717706" y="7885367"/>
            <a:ext cx="1569492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6DF06A5-7428-4848-0634-90C955193597}"/>
              </a:ext>
            </a:extLst>
          </p:cNvPr>
          <p:cNvSpPr txBox="1"/>
          <p:nvPr/>
        </p:nvSpPr>
        <p:spPr>
          <a:xfrm>
            <a:off x="4059233" y="777192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F8C2B69-AB3E-2EEF-8749-01A5371B5FD7}"/>
              </a:ext>
            </a:extLst>
          </p:cNvPr>
          <p:cNvSpPr txBox="1"/>
          <p:nvPr/>
        </p:nvSpPr>
        <p:spPr>
          <a:xfrm>
            <a:off x="4068511" y="798793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988C933-464A-7FC8-4143-FE8B2E3D400C}"/>
              </a:ext>
            </a:extLst>
          </p:cNvPr>
          <p:cNvSpPr txBox="1"/>
          <p:nvPr/>
        </p:nvSpPr>
        <p:spPr>
          <a:xfrm rot="18243495">
            <a:off x="4601073" y="746375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7E5C2E7-D5A6-457B-308F-5C0AD27239AD}"/>
              </a:ext>
            </a:extLst>
          </p:cNvPr>
          <p:cNvSpPr txBox="1"/>
          <p:nvPr/>
        </p:nvSpPr>
        <p:spPr>
          <a:xfrm rot="18243495">
            <a:off x="4788791" y="742678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142E6D-CCB7-7631-4980-9E2DD6BB7D05}"/>
              </a:ext>
            </a:extLst>
          </p:cNvPr>
          <p:cNvSpPr txBox="1"/>
          <p:nvPr/>
        </p:nvSpPr>
        <p:spPr>
          <a:xfrm rot="18243495">
            <a:off x="5012750" y="7420163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VP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269F227-76E5-680D-363F-3D84CD9C5F1C}"/>
              </a:ext>
            </a:extLst>
          </p:cNvPr>
          <p:cNvSpPr txBox="1"/>
          <p:nvPr/>
        </p:nvSpPr>
        <p:spPr>
          <a:xfrm rot="18243495">
            <a:off x="5244661" y="742148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D2A8512-41FF-60FA-3A4A-EB5996101306}"/>
              </a:ext>
            </a:extLst>
          </p:cNvPr>
          <p:cNvSpPr txBox="1"/>
          <p:nvPr/>
        </p:nvSpPr>
        <p:spPr>
          <a:xfrm rot="18243495">
            <a:off x="5692582" y="7424139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397472C-FE93-91C4-7F70-1E7F68155663}"/>
              </a:ext>
            </a:extLst>
          </p:cNvPr>
          <p:cNvSpPr txBox="1"/>
          <p:nvPr/>
        </p:nvSpPr>
        <p:spPr>
          <a:xfrm rot="18243495">
            <a:off x="5892690" y="742546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2873A032-13E1-2679-1A8E-24E44F4E9AE9}"/>
              </a:ext>
            </a:extLst>
          </p:cNvPr>
          <p:cNvSpPr txBox="1"/>
          <p:nvPr/>
        </p:nvSpPr>
        <p:spPr>
          <a:xfrm rot="18243495">
            <a:off x="5476572" y="7422812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C1E1E00-7F6E-61E0-C430-4D77222EDC1B}"/>
              </a:ext>
            </a:extLst>
          </p:cNvPr>
          <p:cNvSpPr txBox="1"/>
          <p:nvPr/>
        </p:nvSpPr>
        <p:spPr>
          <a:xfrm>
            <a:off x="3916418" y="5909960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D248C7-3B1E-186C-BF1C-69E20ADC32B5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18810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図 120">
            <a:extLst>
              <a:ext uri="{FF2B5EF4-FFF2-40B4-BE49-F238E27FC236}">
                <a16:creationId xmlns:a16="http://schemas.microsoft.com/office/drawing/2014/main" id="{7E18F0B6-60FC-11D2-40A0-07A7ACFF6B69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362" y="3384688"/>
            <a:ext cx="3463068" cy="252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FF48357-19E6-1C7B-35D2-A84A02E31225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734" y="6315846"/>
            <a:ext cx="2365577" cy="3248726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67EDDA8-141F-BF2E-F25F-2CE3AE0A291F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734" y="3023813"/>
            <a:ext cx="2365577" cy="324872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A28E8B4D-3C08-D2A2-1A04-2A6ABD46218D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63" y="449539"/>
            <a:ext cx="3461026" cy="252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0FAA92B-299C-B48C-E79C-B123D2D99CB1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250238" y="6192796"/>
            <a:ext cx="2520000" cy="3460801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E5B604DE-1569-90C5-9E5D-59EDB40A43D1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837" y="450455"/>
            <a:ext cx="3459408" cy="2520000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5DFE31A-F6EC-2884-C896-DFD7408A9D1F}"/>
              </a:ext>
            </a:extLst>
          </p:cNvPr>
          <p:cNvSpPr txBox="1"/>
          <p:nvPr/>
        </p:nvSpPr>
        <p:spPr>
          <a:xfrm>
            <a:off x="203873" y="9561600"/>
            <a:ext cx="71502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hole western blot images in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-D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hole western blot images for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, 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ACTB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, D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the manuscript (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E-J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hole western blot images for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E, F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HSP90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G, H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and HDAC1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I, J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the manuscript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Figure 1C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The molecular weight of the samples was calculated using Precision Plus Protein™ Kaleidoscope™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restained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rotein Standards and, sizes are shown in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The red dotted square indicates the proteins of interest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6D24E17-88E5-F39C-3BDF-562287B35EC6}"/>
              </a:ext>
            </a:extLst>
          </p:cNvPr>
          <p:cNvSpPr/>
          <p:nvPr/>
        </p:nvSpPr>
        <p:spPr>
          <a:xfrm>
            <a:off x="1150565" y="1599823"/>
            <a:ext cx="1980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2C362C-9E9D-9605-E3D6-E4FCBD739919}"/>
              </a:ext>
            </a:extLst>
          </p:cNvPr>
          <p:cNvSpPr txBox="1"/>
          <p:nvPr/>
        </p:nvSpPr>
        <p:spPr>
          <a:xfrm>
            <a:off x="575191" y="146713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0AA0D37-6C58-E3EA-C7B9-7FAFA04526C5}"/>
              </a:ext>
            </a:extLst>
          </p:cNvPr>
          <p:cNvSpPr txBox="1"/>
          <p:nvPr/>
        </p:nvSpPr>
        <p:spPr>
          <a:xfrm>
            <a:off x="574944" y="163551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C9AF97-2AFE-169F-2B31-9E7186C6086E}"/>
              </a:ext>
            </a:extLst>
          </p:cNvPr>
          <p:cNvSpPr txBox="1"/>
          <p:nvPr/>
        </p:nvSpPr>
        <p:spPr>
          <a:xfrm rot="18243495">
            <a:off x="1039845" y="115648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6934AE5-157C-4929-337B-ABEF59B93E2D}"/>
              </a:ext>
            </a:extLst>
          </p:cNvPr>
          <p:cNvSpPr txBox="1"/>
          <p:nvPr/>
        </p:nvSpPr>
        <p:spPr>
          <a:xfrm rot="18243495">
            <a:off x="1201711" y="1056180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DEA59C7-DADC-E86B-CC10-CD1B2FA37D23}"/>
              </a:ext>
            </a:extLst>
          </p:cNvPr>
          <p:cNvSpPr txBox="1"/>
          <p:nvPr/>
        </p:nvSpPr>
        <p:spPr>
          <a:xfrm rot="18243495">
            <a:off x="1408527" y="105750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9F01EE4-8874-EB97-356B-838900F783A6}"/>
              </a:ext>
            </a:extLst>
          </p:cNvPr>
          <p:cNvSpPr txBox="1"/>
          <p:nvPr/>
        </p:nvSpPr>
        <p:spPr>
          <a:xfrm rot="18243495">
            <a:off x="1565812" y="1058829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ECED689-FB27-EFD4-D407-5377CD36083A}"/>
              </a:ext>
            </a:extLst>
          </p:cNvPr>
          <p:cNvSpPr txBox="1"/>
          <p:nvPr/>
        </p:nvSpPr>
        <p:spPr>
          <a:xfrm rot="18243495">
            <a:off x="1750018" y="1068107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7F47654-D149-1B0A-D1C4-4BFD6696A172}"/>
              </a:ext>
            </a:extLst>
          </p:cNvPr>
          <p:cNvSpPr txBox="1"/>
          <p:nvPr/>
        </p:nvSpPr>
        <p:spPr>
          <a:xfrm>
            <a:off x="498991" y="126710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0751BAA-D8ED-920E-C418-10F23DB7F79A}"/>
              </a:ext>
            </a:extLst>
          </p:cNvPr>
          <p:cNvSpPr txBox="1"/>
          <p:nvPr/>
        </p:nvSpPr>
        <p:spPr>
          <a:xfrm rot="18243495">
            <a:off x="2001870" y="115648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63AAA17-A3D2-0308-51CC-E3FA0FBEF332}"/>
              </a:ext>
            </a:extLst>
          </p:cNvPr>
          <p:cNvSpPr txBox="1"/>
          <p:nvPr/>
        </p:nvSpPr>
        <p:spPr>
          <a:xfrm rot="18243495">
            <a:off x="2163736" y="1056180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D87F1DA-D0AB-A3E4-49F1-9A205BA7AB65}"/>
              </a:ext>
            </a:extLst>
          </p:cNvPr>
          <p:cNvSpPr txBox="1"/>
          <p:nvPr/>
        </p:nvSpPr>
        <p:spPr>
          <a:xfrm rot="18243495">
            <a:off x="2370552" y="105750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0D06FDD-08F7-3481-B556-7EE79833BA13}"/>
              </a:ext>
            </a:extLst>
          </p:cNvPr>
          <p:cNvSpPr txBox="1"/>
          <p:nvPr/>
        </p:nvSpPr>
        <p:spPr>
          <a:xfrm rot="18243495">
            <a:off x="2527837" y="1058829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80E7964-FCDD-F50D-5744-3D7B20732A67}"/>
              </a:ext>
            </a:extLst>
          </p:cNvPr>
          <p:cNvSpPr txBox="1"/>
          <p:nvPr/>
        </p:nvSpPr>
        <p:spPr>
          <a:xfrm rot="18243495">
            <a:off x="2712043" y="1068107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6BB4A057-4775-2C04-8750-5191FBD4E54F}"/>
              </a:ext>
            </a:extLst>
          </p:cNvPr>
          <p:cNvCxnSpPr/>
          <p:nvPr/>
        </p:nvCxnSpPr>
        <p:spPr>
          <a:xfrm>
            <a:off x="1218239" y="1879822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0334D06B-CB42-4E0E-9F1A-5F24375D6D6E}"/>
              </a:ext>
            </a:extLst>
          </p:cNvPr>
          <p:cNvCxnSpPr/>
          <p:nvPr/>
        </p:nvCxnSpPr>
        <p:spPr>
          <a:xfrm>
            <a:off x="2180264" y="1879822"/>
            <a:ext cx="9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62F1CA1-9D65-F288-9219-94F15802B3E1}"/>
              </a:ext>
            </a:extLst>
          </p:cNvPr>
          <p:cNvSpPr txBox="1"/>
          <p:nvPr/>
        </p:nvSpPr>
        <p:spPr>
          <a:xfrm>
            <a:off x="1208714" y="1889347"/>
            <a:ext cx="90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CB59A60-2E1C-E692-0251-7E06FD6CDA65}"/>
              </a:ext>
            </a:extLst>
          </p:cNvPr>
          <p:cNvSpPr txBox="1"/>
          <p:nvPr/>
        </p:nvSpPr>
        <p:spPr>
          <a:xfrm>
            <a:off x="2227889" y="1889347"/>
            <a:ext cx="90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6490BFDC-6EDD-D5D5-BF78-07C4AFE6651E}"/>
              </a:ext>
            </a:extLst>
          </p:cNvPr>
          <p:cNvSpPr/>
          <p:nvPr/>
        </p:nvSpPr>
        <p:spPr>
          <a:xfrm>
            <a:off x="4455740" y="1552198"/>
            <a:ext cx="2268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C8D090B-0C9C-F33B-B885-C746A9ABE0C0}"/>
              </a:ext>
            </a:extLst>
          </p:cNvPr>
          <p:cNvSpPr txBox="1"/>
          <p:nvPr/>
        </p:nvSpPr>
        <p:spPr>
          <a:xfrm>
            <a:off x="3867666" y="141633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6BBAAC3-C5A7-A1BC-B299-8767FC6CF7FD}"/>
              </a:ext>
            </a:extLst>
          </p:cNvPr>
          <p:cNvSpPr txBox="1"/>
          <p:nvPr/>
        </p:nvSpPr>
        <p:spPr>
          <a:xfrm>
            <a:off x="3867419" y="158471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8F095AD-2C93-02E3-2D94-F84907501600}"/>
              </a:ext>
            </a:extLst>
          </p:cNvPr>
          <p:cNvSpPr txBox="1"/>
          <p:nvPr/>
        </p:nvSpPr>
        <p:spPr>
          <a:xfrm>
            <a:off x="3791466" y="121630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2E750574-3631-791C-A04E-6B8C85098CB7}"/>
              </a:ext>
            </a:extLst>
          </p:cNvPr>
          <p:cNvCxnSpPr/>
          <p:nvPr/>
        </p:nvCxnSpPr>
        <p:spPr>
          <a:xfrm>
            <a:off x="4494839" y="1841722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50D9DE6-4D67-69BC-4D5C-94782082442B}"/>
              </a:ext>
            </a:extLst>
          </p:cNvPr>
          <p:cNvSpPr txBox="1"/>
          <p:nvPr/>
        </p:nvSpPr>
        <p:spPr>
          <a:xfrm>
            <a:off x="4494838" y="1851247"/>
            <a:ext cx="104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046ABBA-0306-8CCE-DBF9-9E8C48EDA83A}"/>
              </a:ext>
            </a:extLst>
          </p:cNvPr>
          <p:cNvSpPr txBox="1"/>
          <p:nvPr/>
        </p:nvSpPr>
        <p:spPr>
          <a:xfrm>
            <a:off x="5609263" y="1851247"/>
            <a:ext cx="104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47F046A-34FA-5A1E-3315-9AAE1B4A5E10}"/>
              </a:ext>
            </a:extLst>
          </p:cNvPr>
          <p:cNvSpPr txBox="1"/>
          <p:nvPr/>
        </p:nvSpPr>
        <p:spPr>
          <a:xfrm rot="18243495">
            <a:off x="4325556" y="111354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F09DC6D-28E0-9C9A-E16E-B7AB3FEACF2B}"/>
              </a:ext>
            </a:extLst>
          </p:cNvPr>
          <p:cNvSpPr txBox="1"/>
          <p:nvPr/>
        </p:nvSpPr>
        <p:spPr>
          <a:xfrm rot="18243495">
            <a:off x="4511001" y="1076576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D1C0765-5CBF-0173-FF1F-3F77E0FC7161}"/>
              </a:ext>
            </a:extLst>
          </p:cNvPr>
          <p:cNvSpPr txBox="1"/>
          <p:nvPr/>
        </p:nvSpPr>
        <p:spPr>
          <a:xfrm rot="18243495">
            <a:off x="4628671" y="941016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VP10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6C443D9-9FC7-6FBA-D829-F1C3FD6D5E8F}"/>
              </a:ext>
            </a:extLst>
          </p:cNvPr>
          <p:cNvSpPr txBox="1"/>
          <p:nvPr/>
        </p:nvSpPr>
        <p:spPr>
          <a:xfrm rot="18243495">
            <a:off x="4875033" y="1071276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4A02B87-42DF-E80D-40D9-87084D18A9BB}"/>
              </a:ext>
            </a:extLst>
          </p:cNvPr>
          <p:cNvSpPr txBox="1"/>
          <p:nvPr/>
        </p:nvSpPr>
        <p:spPr>
          <a:xfrm rot="18243495">
            <a:off x="5215278" y="1075253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43BBE29-F43D-815C-3DA8-A8E52409373C}"/>
              </a:ext>
            </a:extLst>
          </p:cNvPr>
          <p:cNvSpPr txBox="1"/>
          <p:nvPr/>
        </p:nvSpPr>
        <p:spPr>
          <a:xfrm rot="18243495">
            <a:off x="5040554" y="1072600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BF368959-B5CB-D3D1-4211-B0F5B674C2EE}"/>
              </a:ext>
            </a:extLst>
          </p:cNvPr>
          <p:cNvCxnSpPr/>
          <p:nvPr/>
        </p:nvCxnSpPr>
        <p:spPr>
          <a:xfrm>
            <a:off x="5609264" y="1841722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8F49F90-AB36-DD41-D098-88BDC66635DB}"/>
              </a:ext>
            </a:extLst>
          </p:cNvPr>
          <p:cNvSpPr txBox="1"/>
          <p:nvPr/>
        </p:nvSpPr>
        <p:spPr>
          <a:xfrm rot="18243495">
            <a:off x="5459031" y="111354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DF37391-7732-7DA3-EC42-59316C335788}"/>
              </a:ext>
            </a:extLst>
          </p:cNvPr>
          <p:cNvSpPr txBox="1"/>
          <p:nvPr/>
        </p:nvSpPr>
        <p:spPr>
          <a:xfrm rot="18243495">
            <a:off x="5644476" y="1076576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A9EEC23-D2F4-B0F8-02AC-BF303D2B0C65}"/>
              </a:ext>
            </a:extLst>
          </p:cNvPr>
          <p:cNvSpPr txBox="1"/>
          <p:nvPr/>
        </p:nvSpPr>
        <p:spPr>
          <a:xfrm rot="18243495">
            <a:off x="5762146" y="941016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VP10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6BCCD00-9492-50F5-5F40-A05AFF670C9E}"/>
              </a:ext>
            </a:extLst>
          </p:cNvPr>
          <p:cNvSpPr txBox="1"/>
          <p:nvPr/>
        </p:nvSpPr>
        <p:spPr>
          <a:xfrm rot="18243495">
            <a:off x="6008508" y="1071276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CD85F6B-003C-4E5B-9089-320362BBBBBB}"/>
              </a:ext>
            </a:extLst>
          </p:cNvPr>
          <p:cNvSpPr txBox="1"/>
          <p:nvPr/>
        </p:nvSpPr>
        <p:spPr>
          <a:xfrm rot="18243495">
            <a:off x="6348753" y="1075253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39EF30F-A7BC-C202-25A5-C5A9B85ABFE6}"/>
              </a:ext>
            </a:extLst>
          </p:cNvPr>
          <p:cNvSpPr txBox="1"/>
          <p:nvPr/>
        </p:nvSpPr>
        <p:spPr>
          <a:xfrm rot="18243495">
            <a:off x="6174029" y="1072600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DD99DF54-D66A-B175-DA11-89DAE7A4B6DB}"/>
              </a:ext>
            </a:extLst>
          </p:cNvPr>
          <p:cNvSpPr/>
          <p:nvPr/>
        </p:nvSpPr>
        <p:spPr>
          <a:xfrm>
            <a:off x="1198190" y="4335433"/>
            <a:ext cx="1836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AEA276B-D06D-3965-80B8-A70E68C76ED8}"/>
              </a:ext>
            </a:extLst>
          </p:cNvPr>
          <p:cNvSpPr txBox="1"/>
          <p:nvPr/>
        </p:nvSpPr>
        <p:spPr>
          <a:xfrm>
            <a:off x="619641" y="451706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6135176-7CB6-5E4D-55A6-8E5B70E65B66}"/>
              </a:ext>
            </a:extLst>
          </p:cNvPr>
          <p:cNvSpPr txBox="1"/>
          <p:nvPr/>
        </p:nvSpPr>
        <p:spPr>
          <a:xfrm>
            <a:off x="619394" y="467592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F375271-FB1C-D8D0-2D30-7861C23BB73F}"/>
              </a:ext>
            </a:extLst>
          </p:cNvPr>
          <p:cNvSpPr txBox="1"/>
          <p:nvPr/>
        </p:nvSpPr>
        <p:spPr>
          <a:xfrm rot="18243495">
            <a:off x="1077945" y="389209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03C84FA-E219-ADA1-C35C-C5197324B5EA}"/>
              </a:ext>
            </a:extLst>
          </p:cNvPr>
          <p:cNvSpPr txBox="1"/>
          <p:nvPr/>
        </p:nvSpPr>
        <p:spPr>
          <a:xfrm rot="18243495">
            <a:off x="1211236" y="3791790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F90F572-33CE-D2CB-734A-42A097F70701}"/>
              </a:ext>
            </a:extLst>
          </p:cNvPr>
          <p:cNvSpPr txBox="1"/>
          <p:nvPr/>
        </p:nvSpPr>
        <p:spPr>
          <a:xfrm rot="18243495">
            <a:off x="1389477" y="379311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A94581E-D814-D81D-2261-F08DBC7273CE}"/>
              </a:ext>
            </a:extLst>
          </p:cNvPr>
          <p:cNvSpPr txBox="1"/>
          <p:nvPr/>
        </p:nvSpPr>
        <p:spPr>
          <a:xfrm rot="18243495">
            <a:off x="1565812" y="3794439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02B9230-B5DB-5C1D-A124-90D27E814374}"/>
              </a:ext>
            </a:extLst>
          </p:cNvPr>
          <p:cNvSpPr txBox="1"/>
          <p:nvPr/>
        </p:nvSpPr>
        <p:spPr>
          <a:xfrm rot="18243495">
            <a:off x="1740493" y="3803717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716CBA26-D2C7-3ABA-DF6E-0E6E971FAF6A}"/>
              </a:ext>
            </a:extLst>
          </p:cNvPr>
          <p:cNvSpPr txBox="1"/>
          <p:nvPr/>
        </p:nvSpPr>
        <p:spPr>
          <a:xfrm>
            <a:off x="543441" y="431704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DC7FE1D8-CEC1-28DB-CF1B-0E5529765B5E}"/>
              </a:ext>
            </a:extLst>
          </p:cNvPr>
          <p:cNvSpPr txBox="1"/>
          <p:nvPr/>
        </p:nvSpPr>
        <p:spPr>
          <a:xfrm rot="18243495">
            <a:off x="1963770" y="389209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29F2562-C85C-D844-79CA-02CF2FE9A36A}"/>
              </a:ext>
            </a:extLst>
          </p:cNvPr>
          <p:cNvSpPr txBox="1"/>
          <p:nvPr/>
        </p:nvSpPr>
        <p:spPr>
          <a:xfrm rot="18243495">
            <a:off x="2078011" y="3791790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396B0B4-8648-E112-129F-89C1A87C9FDC}"/>
              </a:ext>
            </a:extLst>
          </p:cNvPr>
          <p:cNvSpPr txBox="1"/>
          <p:nvPr/>
        </p:nvSpPr>
        <p:spPr>
          <a:xfrm rot="18243495">
            <a:off x="2265777" y="379311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C937B59-650E-7A22-ADE7-D3102D26182C}"/>
              </a:ext>
            </a:extLst>
          </p:cNvPr>
          <p:cNvSpPr txBox="1"/>
          <p:nvPr/>
        </p:nvSpPr>
        <p:spPr>
          <a:xfrm rot="18243495">
            <a:off x="2423062" y="3794439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EDD684E0-73A3-292D-F57E-BC321F257BEA}"/>
              </a:ext>
            </a:extLst>
          </p:cNvPr>
          <p:cNvSpPr txBox="1"/>
          <p:nvPr/>
        </p:nvSpPr>
        <p:spPr>
          <a:xfrm rot="18243495">
            <a:off x="2616793" y="3794192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BDE57898-8DF6-225D-4C64-E18CD7CCF99D}"/>
              </a:ext>
            </a:extLst>
          </p:cNvPr>
          <p:cNvCxnSpPr/>
          <p:nvPr/>
        </p:nvCxnSpPr>
        <p:spPr>
          <a:xfrm>
            <a:off x="1246814" y="4615432"/>
            <a:ext cx="82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6349A471-64DB-B83A-473A-0362BF5DCE0D}"/>
              </a:ext>
            </a:extLst>
          </p:cNvPr>
          <p:cNvCxnSpPr/>
          <p:nvPr/>
        </p:nvCxnSpPr>
        <p:spPr>
          <a:xfrm>
            <a:off x="2142164" y="4615432"/>
            <a:ext cx="82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4ACB5F1D-DE50-A98E-ADD1-D04F7F378EB8}"/>
              </a:ext>
            </a:extLst>
          </p:cNvPr>
          <p:cNvSpPr txBox="1"/>
          <p:nvPr/>
        </p:nvSpPr>
        <p:spPr>
          <a:xfrm>
            <a:off x="1237207" y="4626429"/>
            <a:ext cx="834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C78B00A0-9788-CD9D-D5EF-D541F5A4E906}"/>
              </a:ext>
            </a:extLst>
          </p:cNvPr>
          <p:cNvSpPr txBox="1"/>
          <p:nvPr/>
        </p:nvSpPr>
        <p:spPr>
          <a:xfrm>
            <a:off x="2142164" y="4624957"/>
            <a:ext cx="82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AC4314AD-26A1-2158-1463-90234C82FC99}"/>
              </a:ext>
            </a:extLst>
          </p:cNvPr>
          <p:cNvSpPr/>
          <p:nvPr/>
        </p:nvSpPr>
        <p:spPr>
          <a:xfrm>
            <a:off x="4455740" y="4125883"/>
            <a:ext cx="2340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F7CD7DBA-DFF0-A24E-DBB8-B7B08D77A41B}"/>
              </a:ext>
            </a:extLst>
          </p:cNvPr>
          <p:cNvSpPr txBox="1"/>
          <p:nvPr/>
        </p:nvSpPr>
        <p:spPr>
          <a:xfrm>
            <a:off x="3854966" y="431386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C285B88-B4DE-FAB3-3D10-88FABE1D3777}"/>
              </a:ext>
            </a:extLst>
          </p:cNvPr>
          <p:cNvSpPr txBox="1"/>
          <p:nvPr/>
        </p:nvSpPr>
        <p:spPr>
          <a:xfrm>
            <a:off x="3854719" y="448225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173479A-DFEA-2BA8-1360-773AA8BA2A0D}"/>
              </a:ext>
            </a:extLst>
          </p:cNvPr>
          <p:cNvSpPr txBox="1"/>
          <p:nvPr/>
        </p:nvSpPr>
        <p:spPr>
          <a:xfrm>
            <a:off x="3778766" y="411384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0D2A10A1-C6CE-CF06-A5C1-B4B5F6FE0A2E}"/>
              </a:ext>
            </a:extLst>
          </p:cNvPr>
          <p:cNvCxnSpPr/>
          <p:nvPr/>
        </p:nvCxnSpPr>
        <p:spPr>
          <a:xfrm>
            <a:off x="4494839" y="4424932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BD3247F-B5DF-3F36-AFB1-403378F022C6}"/>
              </a:ext>
            </a:extLst>
          </p:cNvPr>
          <p:cNvSpPr txBox="1"/>
          <p:nvPr/>
        </p:nvSpPr>
        <p:spPr>
          <a:xfrm>
            <a:off x="4504363" y="4434457"/>
            <a:ext cx="11049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06E758C2-3B59-F4EE-CF58-7372308EF13A}"/>
              </a:ext>
            </a:extLst>
          </p:cNvPr>
          <p:cNvSpPr txBox="1"/>
          <p:nvPr/>
        </p:nvSpPr>
        <p:spPr>
          <a:xfrm>
            <a:off x="5656888" y="4434457"/>
            <a:ext cx="1138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45DEDAC5-8465-4C78-05F5-860C4193C259}"/>
              </a:ext>
            </a:extLst>
          </p:cNvPr>
          <p:cNvSpPr txBox="1"/>
          <p:nvPr/>
        </p:nvSpPr>
        <p:spPr>
          <a:xfrm rot="18243495">
            <a:off x="4335081" y="370627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94F581D6-B5E3-8433-3381-A87BDBC42E00}"/>
              </a:ext>
            </a:extLst>
          </p:cNvPr>
          <p:cNvSpPr txBox="1"/>
          <p:nvPr/>
        </p:nvSpPr>
        <p:spPr>
          <a:xfrm rot="18243495">
            <a:off x="4501476" y="3669311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CP8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095B740-E793-55BD-91C1-BA13EFAF8FC1}"/>
              </a:ext>
            </a:extLst>
          </p:cNvPr>
          <p:cNvSpPr txBox="1"/>
          <p:nvPr/>
        </p:nvSpPr>
        <p:spPr>
          <a:xfrm rot="18243495">
            <a:off x="4628671" y="3533751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VP10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22E7AF5F-2D4E-7FA8-06B4-922978E0EAC2}"/>
              </a:ext>
            </a:extLst>
          </p:cNvPr>
          <p:cNvSpPr txBox="1"/>
          <p:nvPr/>
        </p:nvSpPr>
        <p:spPr>
          <a:xfrm rot="18243495">
            <a:off x="4892938" y="3661750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07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ED926795-369E-7E7B-91D1-5C8A4D31FAFD}"/>
              </a:ext>
            </a:extLst>
          </p:cNvPr>
          <p:cNvSpPr txBox="1"/>
          <p:nvPr/>
        </p:nvSpPr>
        <p:spPr>
          <a:xfrm rot="18243495">
            <a:off x="5281953" y="366798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28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E58527C-4378-60AC-A2E4-31FB8E0317EB}"/>
              </a:ext>
            </a:extLst>
          </p:cNvPr>
          <p:cNvSpPr txBox="1"/>
          <p:nvPr/>
        </p:nvSpPr>
        <p:spPr>
          <a:xfrm rot="18243495">
            <a:off x="5078654" y="366533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13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1148F3D3-D73F-D5C1-6252-54C1A4BD0155}"/>
              </a:ext>
            </a:extLst>
          </p:cNvPr>
          <p:cNvCxnSpPr>
            <a:cxnSpLocks/>
          </p:cNvCxnSpPr>
          <p:nvPr/>
        </p:nvCxnSpPr>
        <p:spPr>
          <a:xfrm>
            <a:off x="5656889" y="4424932"/>
            <a:ext cx="11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D6E5E123-081D-6D1E-4D84-C0819786CE9D}"/>
              </a:ext>
            </a:extLst>
          </p:cNvPr>
          <p:cNvSpPr/>
          <p:nvPr/>
        </p:nvSpPr>
        <p:spPr>
          <a:xfrm>
            <a:off x="1179140" y="7610460"/>
            <a:ext cx="1836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CA0149FD-CDE9-DF42-A0E7-C4D3F0165379}"/>
              </a:ext>
            </a:extLst>
          </p:cNvPr>
          <p:cNvSpPr txBox="1"/>
          <p:nvPr/>
        </p:nvSpPr>
        <p:spPr>
          <a:xfrm>
            <a:off x="613291" y="768731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BB0BC61A-7369-4DD7-ADC7-41E1C161ECAB}"/>
              </a:ext>
            </a:extLst>
          </p:cNvPr>
          <p:cNvSpPr txBox="1"/>
          <p:nvPr/>
        </p:nvSpPr>
        <p:spPr>
          <a:xfrm>
            <a:off x="613044" y="784617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3ACAD9E4-D46E-A895-FFE2-E36B2536DEE7}"/>
              </a:ext>
            </a:extLst>
          </p:cNvPr>
          <p:cNvSpPr txBox="1"/>
          <p:nvPr/>
        </p:nvSpPr>
        <p:spPr>
          <a:xfrm rot="18243495">
            <a:off x="1030320" y="717664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44F47550-9997-8589-B415-4B1972C9ECA5}"/>
              </a:ext>
            </a:extLst>
          </p:cNvPr>
          <p:cNvSpPr txBox="1"/>
          <p:nvPr/>
        </p:nvSpPr>
        <p:spPr>
          <a:xfrm rot="18243495">
            <a:off x="1154086" y="7076342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605B2C3-8DE3-99C7-0A89-CA1197BA000C}"/>
              </a:ext>
            </a:extLst>
          </p:cNvPr>
          <p:cNvSpPr txBox="1"/>
          <p:nvPr/>
        </p:nvSpPr>
        <p:spPr>
          <a:xfrm rot="18243495">
            <a:off x="1341852" y="7077666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4CA403C0-59DF-9D0E-C21E-88AFC31A0D91}"/>
              </a:ext>
            </a:extLst>
          </p:cNvPr>
          <p:cNvSpPr txBox="1"/>
          <p:nvPr/>
        </p:nvSpPr>
        <p:spPr>
          <a:xfrm rot="18243495">
            <a:off x="1518187" y="7069466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66277AE4-47D2-E72C-AF94-09816926AF5E}"/>
              </a:ext>
            </a:extLst>
          </p:cNvPr>
          <p:cNvSpPr txBox="1"/>
          <p:nvPr/>
        </p:nvSpPr>
        <p:spPr>
          <a:xfrm rot="18243495">
            <a:off x="1692868" y="7069219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E9B4EED0-67BC-86A3-888B-0D9A3322C465}"/>
              </a:ext>
            </a:extLst>
          </p:cNvPr>
          <p:cNvSpPr txBox="1"/>
          <p:nvPr/>
        </p:nvSpPr>
        <p:spPr>
          <a:xfrm>
            <a:off x="537091" y="750634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64541B5-C5DC-56E5-8827-2D8BA3BA4687}"/>
              </a:ext>
            </a:extLst>
          </p:cNvPr>
          <p:cNvSpPr txBox="1"/>
          <p:nvPr/>
        </p:nvSpPr>
        <p:spPr>
          <a:xfrm rot="18243495">
            <a:off x="1916145" y="717664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6c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0ECDA575-BC1E-A43C-14AE-A82A6BC1B21F}"/>
              </a:ext>
            </a:extLst>
          </p:cNvPr>
          <p:cNvSpPr txBox="1"/>
          <p:nvPr/>
        </p:nvSpPr>
        <p:spPr>
          <a:xfrm rot="18243495">
            <a:off x="2030386" y="7076342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apa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1896F033-CEBE-192B-B3F4-17205636CE79}"/>
              </a:ext>
            </a:extLst>
          </p:cNvPr>
          <p:cNvSpPr txBox="1"/>
          <p:nvPr/>
        </p:nvSpPr>
        <p:spPr>
          <a:xfrm rot="18243495">
            <a:off x="2218152" y="7077666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1B91454F-56B0-A8C3-8BB3-4FB65DC9750D}"/>
              </a:ext>
            </a:extLst>
          </p:cNvPr>
          <p:cNvSpPr txBox="1"/>
          <p:nvPr/>
        </p:nvSpPr>
        <p:spPr>
          <a:xfrm rot="18243495">
            <a:off x="2394487" y="7078991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C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8DE4BD7-ADA7-60FE-6291-DEFC2792EC90}"/>
              </a:ext>
            </a:extLst>
          </p:cNvPr>
          <p:cNvSpPr txBox="1"/>
          <p:nvPr/>
        </p:nvSpPr>
        <p:spPr>
          <a:xfrm rot="18243495">
            <a:off x="2569168" y="7078744"/>
            <a:ext cx="1025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PAF-Ⅱ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9ABF224B-2B2F-1BA4-CE3F-6C8A9C389C22}"/>
              </a:ext>
            </a:extLst>
          </p:cNvPr>
          <p:cNvCxnSpPr/>
          <p:nvPr/>
        </p:nvCxnSpPr>
        <p:spPr>
          <a:xfrm>
            <a:off x="1199189" y="7880934"/>
            <a:ext cx="82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0E8CB00B-897F-E10E-61C9-18519D38F39A}"/>
              </a:ext>
            </a:extLst>
          </p:cNvPr>
          <p:cNvCxnSpPr/>
          <p:nvPr/>
        </p:nvCxnSpPr>
        <p:spPr>
          <a:xfrm>
            <a:off x="2094539" y="7880934"/>
            <a:ext cx="82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0183071-6E13-80AB-C932-609F96984E77}"/>
              </a:ext>
            </a:extLst>
          </p:cNvPr>
          <p:cNvSpPr txBox="1"/>
          <p:nvPr/>
        </p:nvSpPr>
        <p:spPr>
          <a:xfrm>
            <a:off x="1189582" y="7891931"/>
            <a:ext cx="834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C10B18A6-6A56-F6F9-F076-8821D824419B}"/>
              </a:ext>
            </a:extLst>
          </p:cNvPr>
          <p:cNvSpPr txBox="1"/>
          <p:nvPr/>
        </p:nvSpPr>
        <p:spPr>
          <a:xfrm>
            <a:off x="2094539" y="7890459"/>
            <a:ext cx="82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3C078C35-4841-5328-068D-6B37F37B0463}"/>
              </a:ext>
            </a:extLst>
          </p:cNvPr>
          <p:cNvSpPr txBox="1"/>
          <p:nvPr/>
        </p:nvSpPr>
        <p:spPr>
          <a:xfrm rot="18243495">
            <a:off x="5487606" y="370627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A0A17D2C-434B-F00E-5863-6FD4F8D025D6}"/>
              </a:ext>
            </a:extLst>
          </p:cNvPr>
          <p:cNvSpPr txBox="1"/>
          <p:nvPr/>
        </p:nvSpPr>
        <p:spPr>
          <a:xfrm rot="18243495">
            <a:off x="5654001" y="3669311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CP8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B1E0C33-5C61-C6E3-B5DE-346948F36C9E}"/>
              </a:ext>
            </a:extLst>
          </p:cNvPr>
          <p:cNvSpPr txBox="1"/>
          <p:nvPr/>
        </p:nvSpPr>
        <p:spPr>
          <a:xfrm rot="18243495">
            <a:off x="5781196" y="3533751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VP10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EEF231C8-968F-6942-74CF-96C5FEEF8A35}"/>
              </a:ext>
            </a:extLst>
          </p:cNvPr>
          <p:cNvSpPr txBox="1"/>
          <p:nvPr/>
        </p:nvSpPr>
        <p:spPr>
          <a:xfrm rot="18243495">
            <a:off x="6045463" y="3661750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07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8B92F545-F99A-2EC4-541A-6D9F8B641843}"/>
              </a:ext>
            </a:extLst>
          </p:cNvPr>
          <p:cNvSpPr txBox="1"/>
          <p:nvPr/>
        </p:nvSpPr>
        <p:spPr>
          <a:xfrm rot="18243495">
            <a:off x="6434478" y="366798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28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561DF546-7E89-0B49-4788-E5295398BF32}"/>
              </a:ext>
            </a:extLst>
          </p:cNvPr>
          <p:cNvSpPr txBox="1"/>
          <p:nvPr/>
        </p:nvSpPr>
        <p:spPr>
          <a:xfrm rot="18243495">
            <a:off x="6231179" y="366533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S2-013</a:t>
            </a:r>
            <a:endParaRPr kumimoji="1" lang="ja-JP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id="{65DF135A-0CF8-87D0-2374-32F06B826796}"/>
              </a:ext>
            </a:extLst>
          </p:cNvPr>
          <p:cNvSpPr/>
          <p:nvPr/>
        </p:nvSpPr>
        <p:spPr>
          <a:xfrm>
            <a:off x="4550990" y="7591410"/>
            <a:ext cx="2232000" cy="24566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58AFEEBA-EAF4-0A20-74DC-B813068BCF87}"/>
              </a:ext>
            </a:extLst>
          </p:cNvPr>
          <p:cNvSpPr txBox="1"/>
          <p:nvPr/>
        </p:nvSpPr>
        <p:spPr>
          <a:xfrm>
            <a:off x="3966091" y="765874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9C1293C-BA48-86F5-DD90-8DFD42166D8E}"/>
              </a:ext>
            </a:extLst>
          </p:cNvPr>
          <p:cNvSpPr txBox="1"/>
          <p:nvPr/>
        </p:nvSpPr>
        <p:spPr>
          <a:xfrm>
            <a:off x="3965844" y="781760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523EF25F-2673-30B5-52AB-B03A2E3FE4EA}"/>
              </a:ext>
            </a:extLst>
          </p:cNvPr>
          <p:cNvSpPr txBox="1"/>
          <p:nvPr/>
        </p:nvSpPr>
        <p:spPr>
          <a:xfrm>
            <a:off x="3889891" y="746824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4B59F8EF-493C-3FEA-AD13-76FE1AD5C8CA}"/>
              </a:ext>
            </a:extLst>
          </p:cNvPr>
          <p:cNvCxnSpPr/>
          <p:nvPr/>
        </p:nvCxnSpPr>
        <p:spPr>
          <a:xfrm>
            <a:off x="4551989" y="7880934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3AAE2FB0-A4E4-3706-6460-61DE28A0B305}"/>
              </a:ext>
            </a:extLst>
          </p:cNvPr>
          <p:cNvSpPr txBox="1"/>
          <p:nvPr/>
        </p:nvSpPr>
        <p:spPr>
          <a:xfrm>
            <a:off x="4551988" y="7890459"/>
            <a:ext cx="104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ytoplas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5AFCEA46-10B5-9022-DB89-A381459111AA}"/>
              </a:ext>
            </a:extLst>
          </p:cNvPr>
          <p:cNvSpPr txBox="1"/>
          <p:nvPr/>
        </p:nvSpPr>
        <p:spPr>
          <a:xfrm>
            <a:off x="5666413" y="7890459"/>
            <a:ext cx="104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uclei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F021BE12-2F20-D0FA-7E36-8B7A078CAB35}"/>
              </a:ext>
            </a:extLst>
          </p:cNvPr>
          <p:cNvSpPr txBox="1"/>
          <p:nvPr/>
        </p:nvSpPr>
        <p:spPr>
          <a:xfrm rot="18243495">
            <a:off x="4411281" y="717180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DDCF609D-8FB6-3D7A-AE58-9B4F855993B4}"/>
              </a:ext>
            </a:extLst>
          </p:cNvPr>
          <p:cNvSpPr txBox="1"/>
          <p:nvPr/>
        </p:nvSpPr>
        <p:spPr>
          <a:xfrm rot="18243495">
            <a:off x="4568151" y="713483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3F3DA66A-2A6C-F4DC-32E4-5325C1C13415}"/>
              </a:ext>
            </a:extLst>
          </p:cNvPr>
          <p:cNvSpPr txBox="1"/>
          <p:nvPr/>
        </p:nvSpPr>
        <p:spPr>
          <a:xfrm rot="18243495">
            <a:off x="4685821" y="6999278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VP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A73CA278-9678-3A93-A4A7-EFB2B721D0C7}"/>
              </a:ext>
            </a:extLst>
          </p:cNvPr>
          <p:cNvSpPr txBox="1"/>
          <p:nvPr/>
        </p:nvSpPr>
        <p:spPr>
          <a:xfrm rot="18243495">
            <a:off x="4940563" y="7127277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67D12F0E-1FAB-E501-610B-ABDCF2B1CF9B}"/>
              </a:ext>
            </a:extLst>
          </p:cNvPr>
          <p:cNvSpPr txBox="1"/>
          <p:nvPr/>
        </p:nvSpPr>
        <p:spPr>
          <a:xfrm rot="18243495">
            <a:off x="5301003" y="713351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6EB4D6EC-4D7D-0F5B-A41A-3F8FC49985A5}"/>
              </a:ext>
            </a:extLst>
          </p:cNvPr>
          <p:cNvSpPr txBox="1"/>
          <p:nvPr/>
        </p:nvSpPr>
        <p:spPr>
          <a:xfrm rot="18243495">
            <a:off x="5126279" y="7130862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9ED94764-6470-E30A-5C23-C0C0D97B1924}"/>
              </a:ext>
            </a:extLst>
          </p:cNvPr>
          <p:cNvCxnSpPr/>
          <p:nvPr/>
        </p:nvCxnSpPr>
        <p:spPr>
          <a:xfrm>
            <a:off x="5666414" y="7880934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FD738D80-355C-13B0-82E5-DF838A5A83AF}"/>
              </a:ext>
            </a:extLst>
          </p:cNvPr>
          <p:cNvSpPr txBox="1"/>
          <p:nvPr/>
        </p:nvSpPr>
        <p:spPr>
          <a:xfrm rot="18243495">
            <a:off x="5506656" y="717180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IT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27A5F72C-D29D-7D6D-EC45-B546E7500E0E}"/>
              </a:ext>
            </a:extLst>
          </p:cNvPr>
          <p:cNvSpPr txBox="1"/>
          <p:nvPr/>
        </p:nvSpPr>
        <p:spPr>
          <a:xfrm rot="18243495">
            <a:off x="5663526" y="7134838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CP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BB2A9E56-B4D1-A0DA-4DA4-1FEE67E1ABF9}"/>
              </a:ext>
            </a:extLst>
          </p:cNvPr>
          <p:cNvSpPr txBox="1"/>
          <p:nvPr/>
        </p:nvSpPr>
        <p:spPr>
          <a:xfrm rot="18243495">
            <a:off x="5781196" y="6999278"/>
            <a:ext cx="1196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VP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03AFE999-7E0D-F22B-3F2F-71376623AA67}"/>
              </a:ext>
            </a:extLst>
          </p:cNvPr>
          <p:cNvSpPr txBox="1"/>
          <p:nvPr/>
        </p:nvSpPr>
        <p:spPr>
          <a:xfrm rot="18243495">
            <a:off x="6035938" y="7127277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C924A8B9-1234-FFAB-EDE9-A7760C9A1C99}"/>
              </a:ext>
            </a:extLst>
          </p:cNvPr>
          <p:cNvSpPr txBox="1"/>
          <p:nvPr/>
        </p:nvSpPr>
        <p:spPr>
          <a:xfrm rot="18243495">
            <a:off x="6396378" y="7133515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CD22BD1B-E23D-C731-030B-DA9DFD30943F}"/>
              </a:ext>
            </a:extLst>
          </p:cNvPr>
          <p:cNvSpPr txBox="1"/>
          <p:nvPr/>
        </p:nvSpPr>
        <p:spPr>
          <a:xfrm rot="18243495">
            <a:off x="6221654" y="7130862"/>
            <a:ext cx="884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1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BFF67C41-7D18-6579-34CA-2368F5955FCA}"/>
              </a:ext>
            </a:extLst>
          </p:cNvPr>
          <p:cNvSpPr txBox="1"/>
          <p:nvPr/>
        </p:nvSpPr>
        <p:spPr>
          <a:xfrm>
            <a:off x="281710" y="508779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505FF0BD-2BCF-2BC8-0ECA-078F80F832D9}"/>
              </a:ext>
            </a:extLst>
          </p:cNvPr>
          <p:cNvSpPr txBox="1"/>
          <p:nvPr/>
        </p:nvSpPr>
        <p:spPr>
          <a:xfrm>
            <a:off x="3843861" y="50586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6B032EBC-358F-D6E1-3B8C-067BE7C8F6A6}"/>
              </a:ext>
            </a:extLst>
          </p:cNvPr>
          <p:cNvSpPr txBox="1"/>
          <p:nvPr/>
        </p:nvSpPr>
        <p:spPr>
          <a:xfrm>
            <a:off x="872260" y="308246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5AD1239E-4695-C2FB-4A4D-0AA69EEF4529}"/>
              </a:ext>
            </a:extLst>
          </p:cNvPr>
          <p:cNvSpPr txBox="1"/>
          <p:nvPr/>
        </p:nvSpPr>
        <p:spPr>
          <a:xfrm>
            <a:off x="3847141" y="3432338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D188A44-1A41-7A00-3946-7DF0BAF7EB74}"/>
              </a:ext>
            </a:extLst>
          </p:cNvPr>
          <p:cNvSpPr txBox="1"/>
          <p:nvPr/>
        </p:nvSpPr>
        <p:spPr>
          <a:xfrm>
            <a:off x="872260" y="6376541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B7C192AB-28D0-1942-A1BA-8C2B1DC47D0C}"/>
              </a:ext>
            </a:extLst>
          </p:cNvPr>
          <p:cNvSpPr txBox="1"/>
          <p:nvPr/>
        </p:nvSpPr>
        <p:spPr>
          <a:xfrm>
            <a:off x="3847141" y="672641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05C9E5E-C643-330A-26B3-06863EFA8005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7569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BEFBC2-8A54-5887-8886-5C6D69C799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1AA3F07-FCF6-F562-E69A-AFAF222811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0640" y="854269"/>
            <a:ext cx="1798476" cy="2694666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46FE45-59A6-AEA8-F958-833130B5BA3A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1409C046-637C-77AC-B274-690244FC63A7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561" y="3563953"/>
            <a:ext cx="1520388" cy="2088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65B7070-4E2E-620C-0BAB-76B388A6BB1C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346" y="3565855"/>
            <a:ext cx="1520388" cy="208800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3B42A06-E314-BEE7-5767-FA8E95429991}"/>
              </a:ext>
            </a:extLst>
          </p:cNvPr>
          <p:cNvSpPr txBox="1"/>
          <p:nvPr/>
        </p:nvSpPr>
        <p:spPr>
          <a:xfrm>
            <a:off x="660337" y="364653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059233D-427F-2260-BE86-00E04381F2BD}"/>
              </a:ext>
            </a:extLst>
          </p:cNvPr>
          <p:cNvSpPr txBox="1"/>
          <p:nvPr/>
        </p:nvSpPr>
        <p:spPr>
          <a:xfrm>
            <a:off x="2271705" y="363383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DD34E1E-95DE-89BF-81F7-260721FD9118}"/>
              </a:ext>
            </a:extLst>
          </p:cNvPr>
          <p:cNvSpPr/>
          <p:nvPr/>
        </p:nvSpPr>
        <p:spPr>
          <a:xfrm>
            <a:off x="935100" y="4713014"/>
            <a:ext cx="396000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BABA08C-2C7A-5568-EA01-10AE2C2FBAA6}"/>
              </a:ext>
            </a:extLst>
          </p:cNvPr>
          <p:cNvSpPr txBox="1"/>
          <p:nvPr/>
        </p:nvSpPr>
        <p:spPr>
          <a:xfrm>
            <a:off x="328471" y="454526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9C04436-77C6-7A76-D333-7EAFA7916CCA}"/>
              </a:ext>
            </a:extLst>
          </p:cNvPr>
          <p:cNvSpPr txBox="1"/>
          <p:nvPr/>
        </p:nvSpPr>
        <p:spPr>
          <a:xfrm>
            <a:off x="328874" y="4674351"/>
            <a:ext cx="582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57AAD2E-2C02-36FD-D9A6-EB86D82D7330}"/>
              </a:ext>
            </a:extLst>
          </p:cNvPr>
          <p:cNvSpPr txBox="1"/>
          <p:nvPr/>
        </p:nvSpPr>
        <p:spPr>
          <a:xfrm rot="18472847">
            <a:off x="545358" y="4303558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5D12FB5-3F4D-A74B-415E-28696691DD24}"/>
              </a:ext>
            </a:extLst>
          </p:cNvPr>
          <p:cNvSpPr txBox="1"/>
          <p:nvPr/>
        </p:nvSpPr>
        <p:spPr>
          <a:xfrm rot="18472847">
            <a:off x="679563" y="4305831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6C08D98-64CD-CF14-463D-EB2A2A8EBC87}"/>
              </a:ext>
            </a:extLst>
          </p:cNvPr>
          <p:cNvSpPr txBox="1"/>
          <p:nvPr/>
        </p:nvSpPr>
        <p:spPr>
          <a:xfrm rot="18472847">
            <a:off x="818313" y="4308106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134890F-E4DC-F037-42FB-19DD8C825CD0}"/>
              </a:ext>
            </a:extLst>
          </p:cNvPr>
          <p:cNvSpPr txBox="1"/>
          <p:nvPr/>
        </p:nvSpPr>
        <p:spPr>
          <a:xfrm>
            <a:off x="270559" y="440505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2CA670F5-9A5D-F983-638A-6BCFA4038705}"/>
              </a:ext>
            </a:extLst>
          </p:cNvPr>
          <p:cNvSpPr/>
          <p:nvPr/>
        </p:nvSpPr>
        <p:spPr>
          <a:xfrm>
            <a:off x="2582012" y="4644602"/>
            <a:ext cx="396000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63543606-994F-AC96-BB33-5AA117D82EB5}"/>
              </a:ext>
            </a:extLst>
          </p:cNvPr>
          <p:cNvSpPr txBox="1"/>
          <p:nvPr/>
        </p:nvSpPr>
        <p:spPr>
          <a:xfrm>
            <a:off x="2062783" y="447820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D8EF46F-8A82-DE63-6883-071ED6F55074}"/>
              </a:ext>
            </a:extLst>
          </p:cNvPr>
          <p:cNvSpPr txBox="1"/>
          <p:nvPr/>
        </p:nvSpPr>
        <p:spPr>
          <a:xfrm>
            <a:off x="2063185" y="4607295"/>
            <a:ext cx="532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713DAC22-428D-C401-27F6-2EF3B8B6E203}"/>
              </a:ext>
            </a:extLst>
          </p:cNvPr>
          <p:cNvSpPr txBox="1"/>
          <p:nvPr/>
        </p:nvSpPr>
        <p:spPr>
          <a:xfrm>
            <a:off x="2004871" y="433799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8B7333B-8117-C400-567C-C9556BF7909F}"/>
              </a:ext>
            </a:extLst>
          </p:cNvPr>
          <p:cNvSpPr txBox="1"/>
          <p:nvPr/>
        </p:nvSpPr>
        <p:spPr>
          <a:xfrm>
            <a:off x="104222" y="8818815"/>
            <a:ext cx="73512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ffects of transient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knockdown in S2-007 cells.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RNA expression in S2-007 cells after adenoviral transduction with scrambled control (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Scramble) or two independent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targeting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shMaspin-1 and shMaspin-2), as determined by quantitative real-time PCR. Expression levels were normalized to ACTB (n=3).  ***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 0.001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hole western blot images in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2D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Whole western blot images of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B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B52B282-6F26-CA9C-09AA-FAD9BC41745A}"/>
              </a:ext>
            </a:extLst>
          </p:cNvPr>
          <p:cNvSpPr txBox="1"/>
          <p:nvPr/>
        </p:nvSpPr>
        <p:spPr>
          <a:xfrm>
            <a:off x="494908" y="468484"/>
            <a:ext cx="41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CC52DE20-348E-5BB1-3520-221AF39FBF43}"/>
              </a:ext>
            </a:extLst>
          </p:cNvPr>
          <p:cNvCxnSpPr/>
          <p:nvPr/>
        </p:nvCxnSpPr>
        <p:spPr>
          <a:xfrm>
            <a:off x="1392520" y="1164883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9F3DA01-9614-2D58-74DD-0F45B902757A}"/>
              </a:ext>
            </a:extLst>
          </p:cNvPr>
          <p:cNvSpPr txBox="1"/>
          <p:nvPr/>
        </p:nvSpPr>
        <p:spPr>
          <a:xfrm>
            <a:off x="1424221" y="789005"/>
            <a:ext cx="619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✻✻✻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9337CF52-55A0-B936-B5AD-995DECBCAC45}"/>
              </a:ext>
            </a:extLst>
          </p:cNvPr>
          <p:cNvCxnSpPr/>
          <p:nvPr/>
        </p:nvCxnSpPr>
        <p:spPr>
          <a:xfrm>
            <a:off x="1397423" y="97895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4B367AC-421E-0369-4373-2B40A31F4B35}"/>
              </a:ext>
            </a:extLst>
          </p:cNvPr>
          <p:cNvSpPr txBox="1"/>
          <p:nvPr/>
        </p:nvSpPr>
        <p:spPr>
          <a:xfrm>
            <a:off x="1263337" y="979382"/>
            <a:ext cx="619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8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✻✻✻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3D8674-2FE6-CFB9-053A-E25C5A18A083}"/>
              </a:ext>
            </a:extLst>
          </p:cNvPr>
          <p:cNvSpPr txBox="1"/>
          <p:nvPr/>
        </p:nvSpPr>
        <p:spPr>
          <a:xfrm rot="18472847">
            <a:off x="2176703" y="4249222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EFB8F32-2CD1-9C40-7D1A-D0980BD24035}"/>
              </a:ext>
            </a:extLst>
          </p:cNvPr>
          <p:cNvSpPr txBox="1"/>
          <p:nvPr/>
        </p:nvSpPr>
        <p:spPr>
          <a:xfrm rot="18472847">
            <a:off x="2310908" y="4251495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B33EF3A-EAAC-CAA9-DA66-D96094612C2A}"/>
              </a:ext>
            </a:extLst>
          </p:cNvPr>
          <p:cNvSpPr txBox="1"/>
          <p:nvPr/>
        </p:nvSpPr>
        <p:spPr>
          <a:xfrm rot="18472847">
            <a:off x="2449658" y="4253770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72960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0871B6-D36D-C5E3-0321-B33E17E61E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EB1D63B3-720E-4147-2AA2-A50168976E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265" y="6809299"/>
            <a:ext cx="5558181" cy="359810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179980F-836D-1A0B-81AC-34D0415FEE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265" y="3067348"/>
            <a:ext cx="5558181" cy="3581445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77A144D-FE51-E704-970C-43B8FAB4E94D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1E55EFA-BAF4-596D-41CF-49DBB0A20794}"/>
              </a:ext>
            </a:extLst>
          </p:cNvPr>
          <p:cNvSpPr txBox="1"/>
          <p:nvPr/>
        </p:nvSpPr>
        <p:spPr>
          <a:xfrm>
            <a:off x="452093" y="2951916"/>
            <a:ext cx="41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FC93ED1-C5CA-3F5F-41B6-A9085A5A3D72}"/>
              </a:ext>
            </a:extLst>
          </p:cNvPr>
          <p:cNvSpPr txBox="1"/>
          <p:nvPr/>
        </p:nvSpPr>
        <p:spPr>
          <a:xfrm>
            <a:off x="454209" y="6769013"/>
            <a:ext cx="41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5570463-CDB8-A3DC-8357-11B165DCFD63}"/>
              </a:ext>
            </a:extLst>
          </p:cNvPr>
          <p:cNvGrpSpPr/>
          <p:nvPr/>
        </p:nvGrpSpPr>
        <p:grpSpPr>
          <a:xfrm>
            <a:off x="452093" y="465223"/>
            <a:ext cx="2804461" cy="2486693"/>
            <a:chOff x="452093" y="465223"/>
            <a:chExt cx="2804461" cy="2486693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C786359C-6EC1-F833-32E9-38E8D1D2D15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870" y="465223"/>
              <a:ext cx="2714684" cy="2486693"/>
            </a:xfrm>
            <a:prstGeom prst="rect">
              <a:avLst/>
            </a:prstGeom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D832F560-F088-ED2E-246D-8FD58EEE0E4B}"/>
                </a:ext>
              </a:extLst>
            </p:cNvPr>
            <p:cNvSpPr txBox="1"/>
            <p:nvPr/>
          </p:nvSpPr>
          <p:spPr>
            <a:xfrm>
              <a:off x="452093" y="492958"/>
              <a:ext cx="4106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矢印コネクタ 21">
              <a:extLst>
                <a:ext uri="{FF2B5EF4-FFF2-40B4-BE49-F238E27FC236}">
                  <a16:creationId xmlns:a16="http://schemas.microsoft.com/office/drawing/2014/main" id="{1AD3EC5E-65E7-F66F-0AFA-70774850A823}"/>
                </a:ext>
              </a:extLst>
            </p:cNvPr>
            <p:cNvCxnSpPr/>
            <p:nvPr/>
          </p:nvCxnSpPr>
          <p:spPr>
            <a:xfrm flipH="1">
              <a:off x="1243783" y="490104"/>
              <a:ext cx="720000" cy="0"/>
            </a:xfrm>
            <a:prstGeom prst="straightConnector1">
              <a:avLst/>
            </a:prstGeom>
            <a:ln>
              <a:solidFill>
                <a:srgbClr val="477BA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B8106071-9311-9600-CD3D-6B7C3FE1D1D7}"/>
                </a:ext>
              </a:extLst>
            </p:cNvPr>
            <p:cNvCxnSpPr>
              <a:cxnSpLocks/>
            </p:cNvCxnSpPr>
            <p:nvPr/>
          </p:nvCxnSpPr>
          <p:spPr>
            <a:xfrm>
              <a:off x="2244199" y="487056"/>
              <a:ext cx="720000" cy="0"/>
            </a:xfrm>
            <a:prstGeom prst="straightConnector1">
              <a:avLst/>
            </a:prstGeom>
            <a:ln>
              <a:solidFill>
                <a:srgbClr val="BE535E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3E47D4DC-A58B-A02B-7132-3B186B8E0284}"/>
                </a:ext>
              </a:extLst>
            </p:cNvPr>
            <p:cNvSpPr txBox="1"/>
            <p:nvPr/>
          </p:nvSpPr>
          <p:spPr>
            <a:xfrm>
              <a:off x="1252927" y="495980"/>
              <a:ext cx="72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n>
                    <a:solidFill>
                      <a:srgbClr val="477BA2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Down</a:t>
              </a:r>
            </a:p>
            <a:p>
              <a:pPr algn="ctr"/>
              <a:r>
                <a:rPr kumimoji="1" lang="en-US" altLang="ja-JP" sz="800" dirty="0">
                  <a:ln>
                    <a:solidFill>
                      <a:srgbClr val="477BA2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2,234</a:t>
              </a:r>
              <a:endParaRPr kumimoji="1" lang="ja-JP" altLang="en-US" sz="800" dirty="0">
                <a:ln>
                  <a:solidFill>
                    <a:srgbClr val="477BA2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0E6EAA7B-F0FF-ADF5-46E4-BF4B083F0DEE}"/>
                </a:ext>
              </a:extLst>
            </p:cNvPr>
            <p:cNvSpPr txBox="1"/>
            <p:nvPr/>
          </p:nvSpPr>
          <p:spPr>
            <a:xfrm>
              <a:off x="2237431" y="492932"/>
              <a:ext cx="72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n>
                    <a:solidFill>
                      <a:srgbClr val="BE535E"/>
                    </a:solidFill>
                  </a:ln>
                  <a:solidFill>
                    <a:srgbClr val="BE535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</a:t>
              </a:r>
            </a:p>
            <a:p>
              <a:pPr algn="ctr"/>
              <a:r>
                <a:rPr kumimoji="1" lang="en-US" altLang="ja-JP" sz="800" dirty="0">
                  <a:ln>
                    <a:solidFill>
                      <a:srgbClr val="BE535E"/>
                    </a:solidFill>
                  </a:ln>
                  <a:solidFill>
                    <a:srgbClr val="BE535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,778</a:t>
              </a:r>
              <a:endParaRPr kumimoji="1" lang="ja-JP" altLang="en-US" sz="800" dirty="0">
                <a:ln>
                  <a:solidFill>
                    <a:srgbClr val="BE535E"/>
                  </a:solidFill>
                </a:ln>
                <a:solidFill>
                  <a:srgbClr val="BE535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27307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5D77E9-12E9-A5BF-90BD-329B51C178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4A37C8-89B3-1041-678F-F8A352E8C053}"/>
              </a:ext>
            </a:extLst>
          </p:cNvPr>
          <p:cNvSpPr txBox="1"/>
          <p:nvPr/>
        </p:nvSpPr>
        <p:spPr>
          <a:xfrm>
            <a:off x="48564" y="5518120"/>
            <a:ext cx="745545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fferential gene expression and integrated pathway enrichment analyses in S2-028 (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yt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 and S2-007 (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an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cells.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olcano plot displaying differentially expressed genes in S2-028 cells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yt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, representing the distribution of fold changes (x-axis) and significance (y-axis). Compared to S2-007 cells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an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, the dots indicate upregulated (red), downregulated (blue), and unchanged (gray) genes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TreeMa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ummarizing enriched gene ontology terms for upregulated genes in S2-028 cells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TreeMa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ummarizing enriched gene ontology terms for downregulated genes in S2-028 cells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KEGG pathway map highlighting differentially regulated genes between S2-028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yt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and S2-007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an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cells. 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C765DF6-91BA-8EF0-EF63-6AE026D3C331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9C047E2-6712-FA20-D189-E0CC3A765E56}"/>
              </a:ext>
            </a:extLst>
          </p:cNvPr>
          <p:cNvSpPr txBox="1"/>
          <p:nvPr/>
        </p:nvSpPr>
        <p:spPr>
          <a:xfrm>
            <a:off x="390833" y="617560"/>
            <a:ext cx="41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D4FED2F1-E48E-8CC2-D0A4-9A607A99F6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324" y="692545"/>
            <a:ext cx="5807242" cy="4246402"/>
          </a:xfrm>
          <a:prstGeom prst="rect">
            <a:avLst/>
          </a:prstGeom>
          <a:ln>
            <a:solidFill>
              <a:srgbClr val="00B050"/>
            </a:solidFill>
          </a:ln>
        </p:spPr>
      </p:pic>
    </p:spTree>
    <p:extLst>
      <p:ext uri="{BB962C8B-B14F-4D97-AF65-F5344CB8AC3E}">
        <p14:creationId xmlns:p14="http://schemas.microsoft.com/office/powerpoint/2010/main" val="4259001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549E3BC-0A45-F822-10E3-146AC5E2CD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E3852A0C-8461-D49E-3D5E-1A13A26B3F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754" y="684844"/>
            <a:ext cx="1520388" cy="2088000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82087D79-9BA8-91E0-8CA5-6F46C743FD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0293" y="2850197"/>
            <a:ext cx="1520388" cy="20880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52642F21-44EA-F02B-8B1E-9D084CBA65AE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025" y="682078"/>
            <a:ext cx="1520388" cy="2088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1E0B884B-7CB1-0323-A3E9-0F1C17822768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945" y="2840402"/>
            <a:ext cx="1520388" cy="2088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FB96AFF0-63FB-F821-6E1F-2E502906E993}"/>
              </a:ext>
            </a:extLst>
          </p:cNvPr>
          <p:cNvPicPr>
            <a:picLocks noChangeAspect="1"/>
          </p:cNvPicPr>
          <p:nvPr/>
        </p:nvPicPr>
        <p:blipFill>
          <a:blip r:embed="rId8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119" y="2840402"/>
            <a:ext cx="1520388" cy="2088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6F814E0B-31B5-F50A-4D57-4B49C1377656}"/>
              </a:ext>
            </a:extLst>
          </p:cNvPr>
          <p:cNvPicPr>
            <a:picLocks noChangeAspect="1"/>
          </p:cNvPicPr>
          <p:nvPr/>
        </p:nvPicPr>
        <p:blipFill>
          <a:blip r:embed="rId9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7083" y="687651"/>
            <a:ext cx="1521456" cy="208946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CCDE65A-0469-19F0-62FD-C6D874B632AD}"/>
              </a:ext>
            </a:extLst>
          </p:cNvPr>
          <p:cNvSpPr txBox="1"/>
          <p:nvPr/>
        </p:nvSpPr>
        <p:spPr>
          <a:xfrm>
            <a:off x="95037" y="9529171"/>
            <a:ext cx="7351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hole western blot images in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3D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Whole western blot images of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EGFR,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EGFR,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HER2,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Akt,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E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kt,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F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B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7A0616A-A8F5-4C52-33AC-704D3A3D1773}"/>
              </a:ext>
            </a:extLst>
          </p:cNvPr>
          <p:cNvSpPr txBox="1"/>
          <p:nvPr/>
        </p:nvSpPr>
        <p:spPr>
          <a:xfrm>
            <a:off x="660337" y="75093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1935107-2D7D-B3CB-B634-D797EB720E0E}"/>
              </a:ext>
            </a:extLst>
          </p:cNvPr>
          <p:cNvSpPr txBox="1"/>
          <p:nvPr/>
        </p:nvSpPr>
        <p:spPr>
          <a:xfrm>
            <a:off x="2271705" y="75093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78F4FFD-025C-46CF-A0AB-41DBD06C71BE}"/>
              </a:ext>
            </a:extLst>
          </p:cNvPr>
          <p:cNvSpPr txBox="1"/>
          <p:nvPr/>
        </p:nvSpPr>
        <p:spPr>
          <a:xfrm>
            <a:off x="3891217" y="75093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24A5550-0229-ED10-3E98-091F8002A319}"/>
              </a:ext>
            </a:extLst>
          </p:cNvPr>
          <p:cNvSpPr txBox="1"/>
          <p:nvPr/>
        </p:nvSpPr>
        <p:spPr>
          <a:xfrm>
            <a:off x="3900619" y="75093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14750A6-43A2-C6D9-150B-3B653717034D}"/>
              </a:ext>
            </a:extLst>
          </p:cNvPr>
          <p:cNvSpPr/>
          <p:nvPr/>
        </p:nvSpPr>
        <p:spPr>
          <a:xfrm>
            <a:off x="1227019" y="1688291"/>
            <a:ext cx="304800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73C3B90-28DC-4858-E7B4-70912CB0E267}"/>
              </a:ext>
            </a:extLst>
          </p:cNvPr>
          <p:cNvSpPr txBox="1"/>
          <p:nvPr/>
        </p:nvSpPr>
        <p:spPr>
          <a:xfrm>
            <a:off x="654063" y="152234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219AC46-9DF8-C61A-F6A2-00D85BA7E8A5}"/>
              </a:ext>
            </a:extLst>
          </p:cNvPr>
          <p:cNvSpPr txBox="1"/>
          <p:nvPr/>
        </p:nvSpPr>
        <p:spPr>
          <a:xfrm>
            <a:off x="654470" y="166300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69D8012D-A495-8DBE-6DFD-A6DF345DBA60}"/>
              </a:ext>
            </a:extLst>
          </p:cNvPr>
          <p:cNvSpPr/>
          <p:nvPr/>
        </p:nvSpPr>
        <p:spPr>
          <a:xfrm>
            <a:off x="4500573" y="1440168"/>
            <a:ext cx="286586" cy="98379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B484336-0A35-D09B-10AA-13EA4970C624}"/>
              </a:ext>
            </a:extLst>
          </p:cNvPr>
          <p:cNvSpPr txBox="1"/>
          <p:nvPr/>
        </p:nvSpPr>
        <p:spPr>
          <a:xfrm>
            <a:off x="3932080" y="129477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A7B33E9-A3A5-C2DB-9882-8D55B8D4986C}"/>
              </a:ext>
            </a:extLst>
          </p:cNvPr>
          <p:cNvSpPr txBox="1"/>
          <p:nvPr/>
        </p:nvSpPr>
        <p:spPr>
          <a:xfrm>
            <a:off x="3932487" y="143543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95FA3E5-23A7-E99B-CB42-AF282F6B83CB}"/>
              </a:ext>
            </a:extLst>
          </p:cNvPr>
          <p:cNvSpPr txBox="1"/>
          <p:nvPr/>
        </p:nvSpPr>
        <p:spPr>
          <a:xfrm rot="16200000">
            <a:off x="971480" y="1348339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B68668-AD38-EA9B-70A1-55396FCC77FD}"/>
              </a:ext>
            </a:extLst>
          </p:cNvPr>
          <p:cNvSpPr txBox="1"/>
          <p:nvPr/>
        </p:nvSpPr>
        <p:spPr>
          <a:xfrm rot="16200000">
            <a:off x="1113720" y="1348339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40D31E3-2E28-6200-D4E9-DC61CDD60F92}"/>
              </a:ext>
            </a:extLst>
          </p:cNvPr>
          <p:cNvSpPr txBox="1"/>
          <p:nvPr/>
        </p:nvSpPr>
        <p:spPr>
          <a:xfrm rot="16200000">
            <a:off x="4246034" y="1089834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02E51AB-EB90-E5A4-DCB6-3E7D9C4F3E38}"/>
              </a:ext>
            </a:extLst>
          </p:cNvPr>
          <p:cNvSpPr txBox="1"/>
          <p:nvPr/>
        </p:nvSpPr>
        <p:spPr>
          <a:xfrm rot="16200000">
            <a:off x="4374098" y="1089834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9B858A1-862E-E509-A9F1-EDA14BB25FA2}"/>
              </a:ext>
            </a:extLst>
          </p:cNvPr>
          <p:cNvSpPr txBox="1"/>
          <p:nvPr/>
        </p:nvSpPr>
        <p:spPr>
          <a:xfrm>
            <a:off x="660337" y="2918726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3924736-D21A-BAA3-11EA-B181054C63C8}"/>
              </a:ext>
            </a:extLst>
          </p:cNvPr>
          <p:cNvSpPr txBox="1"/>
          <p:nvPr/>
        </p:nvSpPr>
        <p:spPr>
          <a:xfrm>
            <a:off x="2271705" y="291872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1FED720-0C89-38ED-F692-1635239D6493}"/>
              </a:ext>
            </a:extLst>
          </p:cNvPr>
          <p:cNvSpPr txBox="1"/>
          <p:nvPr/>
        </p:nvSpPr>
        <p:spPr>
          <a:xfrm>
            <a:off x="3891217" y="2918726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52A654D-5841-BE61-ACE6-B56C554B9A0C}"/>
              </a:ext>
            </a:extLst>
          </p:cNvPr>
          <p:cNvSpPr txBox="1"/>
          <p:nvPr/>
        </p:nvSpPr>
        <p:spPr>
          <a:xfrm>
            <a:off x="2281750" y="357507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8202A7F-2FA4-7473-13EA-0EF8B4946E6C}"/>
              </a:ext>
            </a:extLst>
          </p:cNvPr>
          <p:cNvSpPr txBox="1"/>
          <p:nvPr/>
        </p:nvSpPr>
        <p:spPr>
          <a:xfrm>
            <a:off x="2341085" y="385618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4B8C933-5807-E02C-E0DE-8288E359EA50}"/>
              </a:ext>
            </a:extLst>
          </p:cNvPr>
          <p:cNvSpPr txBox="1"/>
          <p:nvPr/>
        </p:nvSpPr>
        <p:spPr>
          <a:xfrm>
            <a:off x="2341083" y="403194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9F38DBED-3A1E-0C15-A1E0-1F47BB5732EA}"/>
              </a:ext>
            </a:extLst>
          </p:cNvPr>
          <p:cNvSpPr/>
          <p:nvPr/>
        </p:nvSpPr>
        <p:spPr>
          <a:xfrm>
            <a:off x="2814313" y="3871876"/>
            <a:ext cx="306000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B437CFD6-9D43-CDB6-9875-5185029C622C}"/>
              </a:ext>
            </a:extLst>
          </p:cNvPr>
          <p:cNvSpPr/>
          <p:nvPr/>
        </p:nvSpPr>
        <p:spPr>
          <a:xfrm>
            <a:off x="4358903" y="4072703"/>
            <a:ext cx="302117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7F292997-38BE-E667-7CE1-870B8A33C949}"/>
              </a:ext>
            </a:extLst>
          </p:cNvPr>
          <p:cNvSpPr txBox="1"/>
          <p:nvPr/>
        </p:nvSpPr>
        <p:spPr>
          <a:xfrm>
            <a:off x="3810792" y="361494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590DFFF-0A66-71B8-E661-07974D4F47E8}"/>
              </a:ext>
            </a:extLst>
          </p:cNvPr>
          <p:cNvSpPr txBox="1"/>
          <p:nvPr/>
        </p:nvSpPr>
        <p:spPr>
          <a:xfrm>
            <a:off x="3891391" y="392439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BA9344BC-E6BE-2A91-8418-5283DAE1D9EB}"/>
              </a:ext>
            </a:extLst>
          </p:cNvPr>
          <p:cNvSpPr txBox="1"/>
          <p:nvPr/>
        </p:nvSpPr>
        <p:spPr>
          <a:xfrm>
            <a:off x="3891389" y="404346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1548020-F9B4-C163-CC7A-A8E6548878DC}"/>
              </a:ext>
            </a:extLst>
          </p:cNvPr>
          <p:cNvSpPr txBox="1"/>
          <p:nvPr/>
        </p:nvSpPr>
        <p:spPr>
          <a:xfrm rot="16200000">
            <a:off x="2553210" y="3506657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3296CE5-2523-38E2-92C4-D5A30E87DD78}"/>
              </a:ext>
            </a:extLst>
          </p:cNvPr>
          <p:cNvSpPr txBox="1"/>
          <p:nvPr/>
        </p:nvSpPr>
        <p:spPr>
          <a:xfrm rot="16200000">
            <a:off x="2695450" y="3506657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5255F432-2B50-E1DD-A0EA-3F3B92664631}"/>
              </a:ext>
            </a:extLst>
          </p:cNvPr>
          <p:cNvSpPr txBox="1"/>
          <p:nvPr/>
        </p:nvSpPr>
        <p:spPr>
          <a:xfrm rot="16200000">
            <a:off x="4112866" y="3711807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F78C4A10-23EE-148B-ABD9-ACDEE1A018E1}"/>
              </a:ext>
            </a:extLst>
          </p:cNvPr>
          <p:cNvSpPr txBox="1"/>
          <p:nvPr/>
        </p:nvSpPr>
        <p:spPr>
          <a:xfrm rot="16200000">
            <a:off x="4255106" y="3711807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DEE657E-D07C-EE9D-7CAB-0BDB44B6F8B8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9AAEFCA-1712-347B-0BAB-7941AB862A61}"/>
              </a:ext>
            </a:extLst>
          </p:cNvPr>
          <p:cNvSpPr txBox="1"/>
          <p:nvPr/>
        </p:nvSpPr>
        <p:spPr>
          <a:xfrm>
            <a:off x="662059" y="357153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173BC91-35B8-8E87-79A2-AC0C896AFF5F}"/>
              </a:ext>
            </a:extLst>
          </p:cNvPr>
          <p:cNvSpPr txBox="1"/>
          <p:nvPr/>
        </p:nvSpPr>
        <p:spPr>
          <a:xfrm>
            <a:off x="721394" y="385263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10F60D8-2FC5-87CD-17A1-35E424E62FD2}"/>
              </a:ext>
            </a:extLst>
          </p:cNvPr>
          <p:cNvSpPr txBox="1"/>
          <p:nvPr/>
        </p:nvSpPr>
        <p:spPr>
          <a:xfrm>
            <a:off x="721392" y="402840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6AB48921-C517-FC1B-07FB-09A184FCEB0E}"/>
              </a:ext>
            </a:extLst>
          </p:cNvPr>
          <p:cNvSpPr/>
          <p:nvPr/>
        </p:nvSpPr>
        <p:spPr>
          <a:xfrm>
            <a:off x="1206664" y="3873633"/>
            <a:ext cx="288658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4515396-5E56-8664-8FC3-B21A88B367E2}"/>
              </a:ext>
            </a:extLst>
          </p:cNvPr>
          <p:cNvSpPr txBox="1"/>
          <p:nvPr/>
        </p:nvSpPr>
        <p:spPr>
          <a:xfrm rot="16200000">
            <a:off x="933519" y="3503114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01208A5-4AB8-F2CB-E3F2-82BFA90AFD89}"/>
              </a:ext>
            </a:extLst>
          </p:cNvPr>
          <p:cNvSpPr txBox="1"/>
          <p:nvPr/>
        </p:nvSpPr>
        <p:spPr>
          <a:xfrm rot="16200000">
            <a:off x="1075759" y="3503114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A22A1FB-9597-CCC5-CCAC-27BA728DD608}"/>
              </a:ext>
            </a:extLst>
          </p:cNvPr>
          <p:cNvSpPr/>
          <p:nvPr/>
        </p:nvSpPr>
        <p:spPr>
          <a:xfrm>
            <a:off x="2794453" y="1624464"/>
            <a:ext cx="304800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29B962D-E486-13E1-F2A0-637DAF39C6D8}"/>
              </a:ext>
            </a:extLst>
          </p:cNvPr>
          <p:cNvSpPr txBox="1"/>
          <p:nvPr/>
        </p:nvSpPr>
        <p:spPr>
          <a:xfrm>
            <a:off x="2224147" y="144791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1208603-9990-4497-6512-03F034A59BAA}"/>
              </a:ext>
            </a:extLst>
          </p:cNvPr>
          <p:cNvSpPr txBox="1"/>
          <p:nvPr/>
        </p:nvSpPr>
        <p:spPr>
          <a:xfrm>
            <a:off x="2224554" y="158857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D33962B2-4D7F-075E-3778-B84033AA1601}"/>
              </a:ext>
            </a:extLst>
          </p:cNvPr>
          <p:cNvSpPr txBox="1"/>
          <p:nvPr/>
        </p:nvSpPr>
        <p:spPr>
          <a:xfrm rot="16200000">
            <a:off x="2541564" y="1273912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9160474-C1F1-D84F-0BFA-78C295BE0F6E}"/>
              </a:ext>
            </a:extLst>
          </p:cNvPr>
          <p:cNvSpPr txBox="1"/>
          <p:nvPr/>
        </p:nvSpPr>
        <p:spPr>
          <a:xfrm rot="16200000">
            <a:off x="2683804" y="1273912"/>
            <a:ext cx="733704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28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88163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図 39">
            <a:extLst>
              <a:ext uri="{FF2B5EF4-FFF2-40B4-BE49-F238E27FC236}">
                <a16:creationId xmlns:a16="http://schemas.microsoft.com/office/drawing/2014/main" id="{F426C7E6-8DCC-5963-8D45-C055683D0256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47" y="677637"/>
            <a:ext cx="1520388" cy="2088000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31780D48-9B65-D697-FFFE-4A0D7304D3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053" y="685657"/>
            <a:ext cx="1520388" cy="2088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0720AF-A45E-4ED1-5C4E-E81600A5B942}"/>
              </a:ext>
            </a:extLst>
          </p:cNvPr>
          <p:cNvSpPr txBox="1"/>
          <p:nvPr/>
        </p:nvSpPr>
        <p:spPr>
          <a:xfrm>
            <a:off x="95037" y="9529171"/>
            <a:ext cx="74646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hole western blot images in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3F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Whole western blot images of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2-007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fter adenoviral transduction with scrambled control (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Scramble) or two independent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targeting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shMaspin-1 and shMaspin-2),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Akt,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kt,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(C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CTB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33B961E-432C-50E7-0AA8-5FFAD925683E}"/>
              </a:ext>
            </a:extLst>
          </p:cNvPr>
          <p:cNvSpPr txBox="1"/>
          <p:nvPr/>
        </p:nvSpPr>
        <p:spPr>
          <a:xfrm>
            <a:off x="3909693" y="73153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DFF09BA-2751-AC67-3196-5E772C39F7B8}"/>
              </a:ext>
            </a:extLst>
          </p:cNvPr>
          <p:cNvSpPr txBox="1"/>
          <p:nvPr/>
        </p:nvSpPr>
        <p:spPr>
          <a:xfrm>
            <a:off x="3919095" y="73153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87B2033-D84C-9483-EB9F-5FAE9F645039}"/>
              </a:ext>
            </a:extLst>
          </p:cNvPr>
          <p:cNvSpPr txBox="1"/>
          <p:nvPr/>
        </p:nvSpPr>
        <p:spPr>
          <a:xfrm>
            <a:off x="2296520" y="769886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133E4A0-D25C-E89B-39B1-733C358E3C00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41AC031-F7D0-9365-AF00-04B19152308F}"/>
              </a:ext>
            </a:extLst>
          </p:cNvPr>
          <p:cNvSpPr txBox="1"/>
          <p:nvPr/>
        </p:nvSpPr>
        <p:spPr>
          <a:xfrm>
            <a:off x="372989" y="185182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6997D784-CFE6-19C2-3ED7-372E0777A8CC}"/>
              </a:ext>
            </a:extLst>
          </p:cNvPr>
          <p:cNvSpPr/>
          <p:nvPr/>
        </p:nvSpPr>
        <p:spPr>
          <a:xfrm>
            <a:off x="2538632" y="1742656"/>
            <a:ext cx="430759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A70C5A0-921F-083E-ACFB-C0D8A6144197}"/>
              </a:ext>
            </a:extLst>
          </p:cNvPr>
          <p:cNvSpPr txBox="1"/>
          <p:nvPr/>
        </p:nvSpPr>
        <p:spPr>
          <a:xfrm rot="18472847">
            <a:off x="2283549" y="1178408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, </a:t>
            </a:r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FF3B89B2-8800-63B5-602B-A4C2238F66DB}"/>
              </a:ext>
            </a:extLst>
          </p:cNvPr>
          <p:cNvSpPr txBox="1"/>
          <p:nvPr/>
        </p:nvSpPr>
        <p:spPr>
          <a:xfrm rot="18472847">
            <a:off x="2417754" y="1180681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, 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47AAA064-F2A7-E80D-3521-AE76906073AA}"/>
              </a:ext>
            </a:extLst>
          </p:cNvPr>
          <p:cNvSpPr txBox="1"/>
          <p:nvPr/>
        </p:nvSpPr>
        <p:spPr>
          <a:xfrm rot="18472847">
            <a:off x="2556504" y="1182956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2-007, 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80A5526F-F6FC-6C6A-A0E7-EF0A4CA82C49}"/>
              </a:ext>
            </a:extLst>
          </p:cNvPr>
          <p:cNvSpPr txBox="1"/>
          <p:nvPr/>
        </p:nvSpPr>
        <p:spPr>
          <a:xfrm rot="18472847">
            <a:off x="486722" y="1445092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B8A7D2AC-2F99-F650-1066-43B205F5F53D}"/>
              </a:ext>
            </a:extLst>
          </p:cNvPr>
          <p:cNvSpPr txBox="1"/>
          <p:nvPr/>
        </p:nvSpPr>
        <p:spPr>
          <a:xfrm rot="18472847">
            <a:off x="620927" y="1447365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A6D9417-B27C-CBF7-8D2C-2511B30BC06D}"/>
              </a:ext>
            </a:extLst>
          </p:cNvPr>
          <p:cNvSpPr txBox="1"/>
          <p:nvPr/>
        </p:nvSpPr>
        <p:spPr>
          <a:xfrm rot="18472847">
            <a:off x="759677" y="1449640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82A15A4-6259-88BA-119D-B4C0A3C873C1}"/>
              </a:ext>
            </a:extLst>
          </p:cNvPr>
          <p:cNvSpPr txBox="1"/>
          <p:nvPr/>
        </p:nvSpPr>
        <p:spPr>
          <a:xfrm>
            <a:off x="671146" y="742915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16834E2-3623-AEAA-332A-CF7A920C1ECC}"/>
              </a:ext>
            </a:extLst>
          </p:cNvPr>
          <p:cNvSpPr txBox="1"/>
          <p:nvPr/>
        </p:nvSpPr>
        <p:spPr>
          <a:xfrm>
            <a:off x="2282514" y="742914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図 36">
            <a:extLst>
              <a:ext uri="{FF2B5EF4-FFF2-40B4-BE49-F238E27FC236}">
                <a16:creationId xmlns:a16="http://schemas.microsoft.com/office/drawing/2014/main" id="{01950B91-7E23-B3E7-6283-B2AB46BE6B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2285" y="677637"/>
            <a:ext cx="1520388" cy="20880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850FFF55-9A94-CA00-E764-B38FCD41D1A3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5987" y="677637"/>
            <a:ext cx="1520388" cy="2088000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355E855-E1EA-AB33-6F89-47CEAAE9088D}"/>
              </a:ext>
            </a:extLst>
          </p:cNvPr>
          <p:cNvSpPr txBox="1"/>
          <p:nvPr/>
        </p:nvSpPr>
        <p:spPr>
          <a:xfrm>
            <a:off x="3633055" y="1599925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5533209-0FFF-D10A-858F-AE2B14140D3B}"/>
              </a:ext>
            </a:extLst>
          </p:cNvPr>
          <p:cNvSpPr txBox="1"/>
          <p:nvPr/>
        </p:nvSpPr>
        <p:spPr>
          <a:xfrm>
            <a:off x="3633053" y="1718988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4BAA7FC-10D3-3A10-98B8-AFADE5CD7667}"/>
              </a:ext>
            </a:extLst>
          </p:cNvPr>
          <p:cNvSpPr txBox="1"/>
          <p:nvPr/>
        </p:nvSpPr>
        <p:spPr>
          <a:xfrm>
            <a:off x="295059" y="155570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8DB347F-76A5-54FC-A531-A02987EC6886}"/>
              </a:ext>
            </a:extLst>
          </p:cNvPr>
          <p:cNvSpPr txBox="1"/>
          <p:nvPr/>
        </p:nvSpPr>
        <p:spPr>
          <a:xfrm>
            <a:off x="1944174" y="150793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96DE95D-46C2-94B2-2756-5E77EAD77C32}"/>
              </a:ext>
            </a:extLst>
          </p:cNvPr>
          <p:cNvSpPr txBox="1"/>
          <p:nvPr/>
        </p:nvSpPr>
        <p:spPr>
          <a:xfrm>
            <a:off x="2003509" y="1807233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69DEF832-8E9A-60C0-B2C9-3CE58154EE9D}"/>
              </a:ext>
            </a:extLst>
          </p:cNvPr>
          <p:cNvSpPr/>
          <p:nvPr/>
        </p:nvSpPr>
        <p:spPr>
          <a:xfrm>
            <a:off x="4150864" y="1734636"/>
            <a:ext cx="430759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662C6A3-072D-2125-B584-142EE3E7E625}"/>
              </a:ext>
            </a:extLst>
          </p:cNvPr>
          <p:cNvSpPr txBox="1"/>
          <p:nvPr/>
        </p:nvSpPr>
        <p:spPr>
          <a:xfrm rot="18472847">
            <a:off x="3760609" y="1321463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0F0ACBD-3383-E9C7-2104-E297AB88C4D2}"/>
              </a:ext>
            </a:extLst>
          </p:cNvPr>
          <p:cNvSpPr txBox="1"/>
          <p:nvPr/>
        </p:nvSpPr>
        <p:spPr>
          <a:xfrm rot="18472847">
            <a:off x="3894814" y="1323736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2ACB427-B8B2-42C9-ADB3-346A783ECFC6}"/>
              </a:ext>
            </a:extLst>
          </p:cNvPr>
          <p:cNvSpPr txBox="1"/>
          <p:nvPr/>
        </p:nvSpPr>
        <p:spPr>
          <a:xfrm rot="18472847">
            <a:off x="4033564" y="1326011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13162427-B936-7342-39BD-EA8D71DB5F6B}"/>
              </a:ext>
            </a:extLst>
          </p:cNvPr>
          <p:cNvSpPr/>
          <p:nvPr/>
        </p:nvSpPr>
        <p:spPr>
          <a:xfrm>
            <a:off x="2520043" y="1824008"/>
            <a:ext cx="430759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0422B31-30B8-5CF9-3211-29D8D6A07DF8}"/>
              </a:ext>
            </a:extLst>
          </p:cNvPr>
          <p:cNvSpPr txBox="1"/>
          <p:nvPr/>
        </p:nvSpPr>
        <p:spPr>
          <a:xfrm rot="18472847">
            <a:off x="2142287" y="1418785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</a:t>
            </a:r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Scramble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C9329BD-9526-3530-0969-B41DFAA08CA9}"/>
              </a:ext>
            </a:extLst>
          </p:cNvPr>
          <p:cNvSpPr txBox="1"/>
          <p:nvPr/>
        </p:nvSpPr>
        <p:spPr>
          <a:xfrm rot="18472847">
            <a:off x="2276492" y="1421058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1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8CA5DFF-49D8-1CA8-E648-B8D49E7688BC}"/>
              </a:ext>
            </a:extLst>
          </p:cNvPr>
          <p:cNvSpPr txBox="1"/>
          <p:nvPr/>
        </p:nvSpPr>
        <p:spPr>
          <a:xfrm rot="18472847">
            <a:off x="2415242" y="1423333"/>
            <a:ext cx="1275068" cy="275721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h-Maspin-2</a:t>
            </a:r>
            <a:endParaRPr lang="ja-JP" sz="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D774E24A-FB13-9926-7087-AA26F1FE8449}"/>
              </a:ext>
            </a:extLst>
          </p:cNvPr>
          <p:cNvSpPr/>
          <p:nvPr/>
        </p:nvSpPr>
        <p:spPr>
          <a:xfrm>
            <a:off x="866332" y="1849028"/>
            <a:ext cx="430759" cy="109243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3A9DB5F-1E6B-D33B-0ED7-EAD4122F664A}"/>
              </a:ext>
            </a:extLst>
          </p:cNvPr>
          <p:cNvSpPr txBox="1"/>
          <p:nvPr/>
        </p:nvSpPr>
        <p:spPr>
          <a:xfrm>
            <a:off x="2268298" y="739867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1DC31B9-D330-33C0-E448-B6E143A54CFC}"/>
              </a:ext>
            </a:extLst>
          </p:cNvPr>
          <p:cNvSpPr txBox="1"/>
          <p:nvPr/>
        </p:nvSpPr>
        <p:spPr>
          <a:xfrm>
            <a:off x="3892882" y="736819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92371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C96F29A-5AD8-52F2-DEA8-37BF8EB30D91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206" y="1556944"/>
            <a:ext cx="3014505" cy="413992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D936D13-4E77-E36D-341E-E80E55A8B52A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3964" y="1556944"/>
            <a:ext cx="3014505" cy="4139921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DD34E1E-95DE-89BF-81F7-260721FD9118}"/>
              </a:ext>
            </a:extLst>
          </p:cNvPr>
          <p:cNvSpPr/>
          <p:nvPr/>
        </p:nvSpPr>
        <p:spPr>
          <a:xfrm>
            <a:off x="1255591" y="3865332"/>
            <a:ext cx="2016000" cy="252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BABA08C-2C7A-5568-EA01-10AE2C2FBAA6}"/>
              </a:ext>
            </a:extLst>
          </p:cNvPr>
          <p:cNvSpPr txBox="1"/>
          <p:nvPr/>
        </p:nvSpPr>
        <p:spPr>
          <a:xfrm>
            <a:off x="562113" y="3687898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9C04436-77C6-7A76-D333-7EAFA7916CCA}"/>
              </a:ext>
            </a:extLst>
          </p:cNvPr>
          <p:cNvSpPr txBox="1"/>
          <p:nvPr/>
        </p:nvSpPr>
        <p:spPr>
          <a:xfrm>
            <a:off x="571391" y="394485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BF3BE7E2-7F96-A37E-20AF-59922C83924A}"/>
              </a:ext>
            </a:extLst>
          </p:cNvPr>
          <p:cNvSpPr/>
          <p:nvPr/>
        </p:nvSpPr>
        <p:spPr>
          <a:xfrm>
            <a:off x="4533338" y="3908548"/>
            <a:ext cx="2016000" cy="252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FA9F096-78F2-30C5-9AE8-460AE70A4321}"/>
              </a:ext>
            </a:extLst>
          </p:cNvPr>
          <p:cNvSpPr txBox="1"/>
          <p:nvPr/>
        </p:nvSpPr>
        <p:spPr>
          <a:xfrm>
            <a:off x="3853034" y="378523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4814EE-2A37-CC57-4318-D4C451F1BF82}"/>
              </a:ext>
            </a:extLst>
          </p:cNvPr>
          <p:cNvSpPr txBox="1"/>
          <p:nvPr/>
        </p:nvSpPr>
        <p:spPr>
          <a:xfrm>
            <a:off x="3862312" y="4042184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0720AF-A45E-4ED1-5C4E-E81600A5B942}"/>
              </a:ext>
            </a:extLst>
          </p:cNvPr>
          <p:cNvSpPr txBox="1"/>
          <p:nvPr/>
        </p:nvSpPr>
        <p:spPr>
          <a:xfrm>
            <a:off x="325291" y="6649888"/>
            <a:ext cx="69724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hole western blot images in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Whole western blot images for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ACTB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the manuscript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Figure 4A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The molecular weight of the samples was calculated using Precision Plus Protein™ Kaleidoscope™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restained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rotein Standards, and sizes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are indicated. Red dotted square indicates the proteins of interest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74DB55-B7A4-A034-C6F6-6265C056B56D}"/>
              </a:ext>
            </a:extLst>
          </p:cNvPr>
          <p:cNvSpPr txBox="1"/>
          <p:nvPr/>
        </p:nvSpPr>
        <p:spPr>
          <a:xfrm>
            <a:off x="3987093" y="1612419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3B42A06-E314-BEE7-5767-FA8E95429991}"/>
              </a:ext>
            </a:extLst>
          </p:cNvPr>
          <p:cNvSpPr txBox="1"/>
          <p:nvPr/>
        </p:nvSpPr>
        <p:spPr>
          <a:xfrm>
            <a:off x="687633" y="1612419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A0E7CEA-F153-0105-5E25-B79FF10FAD11}"/>
              </a:ext>
            </a:extLst>
          </p:cNvPr>
          <p:cNvSpPr txBox="1"/>
          <p:nvPr/>
        </p:nvSpPr>
        <p:spPr>
          <a:xfrm rot="18318998">
            <a:off x="1329284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BCF73FE-7664-0506-11F7-8373EE11D1F8}"/>
              </a:ext>
            </a:extLst>
          </p:cNvPr>
          <p:cNvSpPr txBox="1"/>
          <p:nvPr/>
        </p:nvSpPr>
        <p:spPr>
          <a:xfrm rot="18318998">
            <a:off x="1085444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6C365FB-30F6-E4A3-D2B7-8336A6E35A6A}"/>
              </a:ext>
            </a:extLst>
          </p:cNvPr>
          <p:cNvSpPr txBox="1"/>
          <p:nvPr/>
        </p:nvSpPr>
        <p:spPr>
          <a:xfrm rot="18318998">
            <a:off x="1842872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A46C8F6-27E7-06A0-365E-DD74490D034D}"/>
              </a:ext>
            </a:extLst>
          </p:cNvPr>
          <p:cNvSpPr txBox="1"/>
          <p:nvPr/>
        </p:nvSpPr>
        <p:spPr>
          <a:xfrm rot="18318998">
            <a:off x="1571600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AB11F54-3AF8-8ADA-8045-576D3B37BD53}"/>
              </a:ext>
            </a:extLst>
          </p:cNvPr>
          <p:cNvSpPr txBox="1"/>
          <p:nvPr/>
        </p:nvSpPr>
        <p:spPr>
          <a:xfrm rot="18318998">
            <a:off x="2301596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5EB139D-A15E-743B-11F0-F3739D08B3A9}"/>
              </a:ext>
            </a:extLst>
          </p:cNvPr>
          <p:cNvSpPr txBox="1"/>
          <p:nvPr/>
        </p:nvSpPr>
        <p:spPr>
          <a:xfrm rot="18318998">
            <a:off x="2085188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3278848-0B99-DB74-1180-47B51C610C3F}"/>
              </a:ext>
            </a:extLst>
          </p:cNvPr>
          <p:cNvSpPr txBox="1"/>
          <p:nvPr/>
        </p:nvSpPr>
        <p:spPr>
          <a:xfrm rot="18318998">
            <a:off x="2769464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2AC5FE-03ED-EB09-5B7B-CE0305B6AF79}"/>
              </a:ext>
            </a:extLst>
          </p:cNvPr>
          <p:cNvSpPr txBox="1"/>
          <p:nvPr/>
        </p:nvSpPr>
        <p:spPr>
          <a:xfrm rot="18318998">
            <a:off x="2543912" y="3232772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930B007-4AAB-741D-3584-4F18332E5008}"/>
              </a:ext>
            </a:extLst>
          </p:cNvPr>
          <p:cNvSpPr txBox="1"/>
          <p:nvPr/>
        </p:nvSpPr>
        <p:spPr>
          <a:xfrm rot="18318998">
            <a:off x="4599788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8313861-AE22-ADBF-B89C-9510ABD83428}"/>
              </a:ext>
            </a:extLst>
          </p:cNvPr>
          <p:cNvSpPr txBox="1"/>
          <p:nvPr/>
        </p:nvSpPr>
        <p:spPr>
          <a:xfrm rot="18318998">
            <a:off x="4355948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DFA89E-0370-22E6-B716-4CCB41B5C51E}"/>
              </a:ext>
            </a:extLst>
          </p:cNvPr>
          <p:cNvSpPr txBox="1"/>
          <p:nvPr/>
        </p:nvSpPr>
        <p:spPr>
          <a:xfrm rot="18318998">
            <a:off x="5113376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03624EE-0749-2C43-0758-BF28F6DB2593}"/>
              </a:ext>
            </a:extLst>
          </p:cNvPr>
          <p:cNvSpPr txBox="1"/>
          <p:nvPr/>
        </p:nvSpPr>
        <p:spPr>
          <a:xfrm rot="18318998">
            <a:off x="4842104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4BFF27C-5198-DCD0-B429-D6744B7B1609}"/>
              </a:ext>
            </a:extLst>
          </p:cNvPr>
          <p:cNvSpPr txBox="1"/>
          <p:nvPr/>
        </p:nvSpPr>
        <p:spPr>
          <a:xfrm rot="18318998">
            <a:off x="5572100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21BBED0-3C49-0898-25FA-81BF91B804AB}"/>
              </a:ext>
            </a:extLst>
          </p:cNvPr>
          <p:cNvSpPr txBox="1"/>
          <p:nvPr/>
        </p:nvSpPr>
        <p:spPr>
          <a:xfrm rot="18318998">
            <a:off x="5355692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AD19085-0B07-81F5-957A-4C62836BB72C}"/>
              </a:ext>
            </a:extLst>
          </p:cNvPr>
          <p:cNvSpPr txBox="1"/>
          <p:nvPr/>
        </p:nvSpPr>
        <p:spPr>
          <a:xfrm rot="18318998">
            <a:off x="6039968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-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B01BA09-4AF2-CDAD-088D-1C88265A0813}"/>
              </a:ext>
            </a:extLst>
          </p:cNvPr>
          <p:cNvSpPr txBox="1"/>
          <p:nvPr/>
        </p:nvSpPr>
        <p:spPr>
          <a:xfrm rot="18318998">
            <a:off x="5814416" y="3229724"/>
            <a:ext cx="1279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65F5A61-3EA2-FF09-ABCB-3D46D05CFD3B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altLang="ja-JP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0968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0720AF-A45E-4ED1-5C4E-E81600A5B942}"/>
              </a:ext>
            </a:extLst>
          </p:cNvPr>
          <p:cNvSpPr txBox="1"/>
          <p:nvPr/>
        </p:nvSpPr>
        <p:spPr>
          <a:xfrm>
            <a:off x="176841" y="8963973"/>
            <a:ext cx="71908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ell proliferation and whole western blot images of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xpressing established PDAC cell lines in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Cell proliferation of four cell lines transfected with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ZsGree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only (-ctrl) or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in-ZsGree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was measured at 6 h, 24 h, 48 h, and 72 h, and data were normalized to the corresponding 6 h value. Data are shown as the mean ± SD (n = 3)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-H)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hole western blot images for established cell lines in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-Akt for PANC-1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-Akt for S2-020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TB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0887CB-338D-B507-B0EA-7EACAA5B5625}"/>
              </a:ext>
            </a:extLst>
          </p:cNvPr>
          <p:cNvSpPr txBox="1"/>
          <p:nvPr/>
        </p:nvSpPr>
        <p:spPr>
          <a:xfrm>
            <a:off x="6435" y="-13700"/>
            <a:ext cx="37779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altLang="ja-JP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7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図 86">
            <a:extLst>
              <a:ext uri="{FF2B5EF4-FFF2-40B4-BE49-F238E27FC236}">
                <a16:creationId xmlns:a16="http://schemas.microsoft.com/office/drawing/2014/main" id="{550F8DAE-BB92-9764-A663-7E410047DECE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865" y="4270814"/>
            <a:ext cx="1512524" cy="2077200"/>
          </a:xfrm>
          <a:prstGeom prst="rect">
            <a:avLst/>
          </a:prstGeom>
        </p:spPr>
      </p:pic>
      <p:pic>
        <p:nvPicPr>
          <p:cNvPr id="84" name="図 83">
            <a:extLst>
              <a:ext uri="{FF2B5EF4-FFF2-40B4-BE49-F238E27FC236}">
                <a16:creationId xmlns:a16="http://schemas.microsoft.com/office/drawing/2014/main" id="{284DF886-3486-E8CD-EC0E-3D340B3DC126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431" y="6488385"/>
            <a:ext cx="1512524" cy="2077200"/>
          </a:xfrm>
          <a:prstGeom prst="rect">
            <a:avLst/>
          </a:prstGeom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id="{FC49B546-FFE6-AC23-BD83-C9783774B082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2441" y="4283909"/>
            <a:ext cx="1512524" cy="2077200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46E44088-0D4C-7E45-1D5C-E5C06C5019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9239" y="4270814"/>
            <a:ext cx="1512524" cy="2077200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74A838D5-4EE5-56AF-4A82-FB8A8BAC36B8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7845" y="4274404"/>
            <a:ext cx="1512524" cy="20772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DFF09BA-2751-AC67-3196-5E772C39F7B8}"/>
              </a:ext>
            </a:extLst>
          </p:cNvPr>
          <p:cNvSpPr txBox="1"/>
          <p:nvPr/>
        </p:nvSpPr>
        <p:spPr>
          <a:xfrm>
            <a:off x="514174" y="4360403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E5F8E9F-5624-16C6-D423-0D65CD9A6064}"/>
              </a:ext>
            </a:extLst>
          </p:cNvPr>
          <p:cNvSpPr txBox="1"/>
          <p:nvPr/>
        </p:nvSpPr>
        <p:spPr>
          <a:xfrm>
            <a:off x="3775098" y="4327628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BD06F3D-91DA-785F-CF5A-B88096C6499A}"/>
              </a:ext>
            </a:extLst>
          </p:cNvPr>
          <p:cNvSpPr txBox="1"/>
          <p:nvPr/>
        </p:nvSpPr>
        <p:spPr>
          <a:xfrm>
            <a:off x="5407730" y="4343529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87B2033-D84C-9483-EB9F-5FAE9F645039}"/>
              </a:ext>
            </a:extLst>
          </p:cNvPr>
          <p:cNvSpPr txBox="1"/>
          <p:nvPr/>
        </p:nvSpPr>
        <p:spPr>
          <a:xfrm>
            <a:off x="484663" y="6548006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B23A5713-434E-9551-1CF8-632FC573BF15}"/>
              </a:ext>
            </a:extLst>
          </p:cNvPr>
          <p:cNvSpPr txBox="1"/>
          <p:nvPr/>
        </p:nvSpPr>
        <p:spPr>
          <a:xfrm>
            <a:off x="187745" y="515808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758D610F-D2C3-1824-0F25-E9C8D48C4150}"/>
              </a:ext>
            </a:extLst>
          </p:cNvPr>
          <p:cNvSpPr txBox="1"/>
          <p:nvPr/>
        </p:nvSpPr>
        <p:spPr>
          <a:xfrm>
            <a:off x="188152" y="5298751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8350BDF-4B5D-4AF6-7B54-2A65F6D9F1DA}"/>
              </a:ext>
            </a:extLst>
          </p:cNvPr>
          <p:cNvSpPr txBox="1"/>
          <p:nvPr/>
        </p:nvSpPr>
        <p:spPr>
          <a:xfrm>
            <a:off x="192144" y="543318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D12C4B8-BB12-7B93-7A23-1F0C62B07C7A}"/>
              </a:ext>
            </a:extLst>
          </p:cNvPr>
          <p:cNvSpPr txBox="1"/>
          <p:nvPr/>
        </p:nvSpPr>
        <p:spPr>
          <a:xfrm>
            <a:off x="5034038" y="520861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C82C77B-54D5-43A1-3EB9-8B5FE79ACA0B}"/>
              </a:ext>
            </a:extLst>
          </p:cNvPr>
          <p:cNvSpPr txBox="1"/>
          <p:nvPr/>
        </p:nvSpPr>
        <p:spPr>
          <a:xfrm>
            <a:off x="5083916" y="540083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6D82195-809E-6C97-A85F-522295DD6E0A}"/>
              </a:ext>
            </a:extLst>
          </p:cNvPr>
          <p:cNvSpPr txBox="1"/>
          <p:nvPr/>
        </p:nvSpPr>
        <p:spPr>
          <a:xfrm>
            <a:off x="5094546" y="552639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CCA95A8D-0A89-3154-A6D0-E0199FD76008}"/>
              </a:ext>
            </a:extLst>
          </p:cNvPr>
          <p:cNvSpPr txBox="1"/>
          <p:nvPr/>
        </p:nvSpPr>
        <p:spPr>
          <a:xfrm rot="5400000">
            <a:off x="507384" y="5052789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411D4159-BEA7-2473-BB47-5A5B10BFF31E}"/>
              </a:ext>
            </a:extLst>
          </p:cNvPr>
          <p:cNvCxnSpPr>
            <a:cxnSpLocks/>
          </p:cNvCxnSpPr>
          <p:nvPr/>
        </p:nvCxnSpPr>
        <p:spPr>
          <a:xfrm>
            <a:off x="811657" y="495715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D5673C5E-27DF-E168-2320-F849B8ED2CCF}"/>
              </a:ext>
            </a:extLst>
          </p:cNvPr>
          <p:cNvSpPr txBox="1"/>
          <p:nvPr/>
        </p:nvSpPr>
        <p:spPr>
          <a:xfrm rot="5400000">
            <a:off x="648017" y="5042614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C480EFE5-7BC0-144F-58E8-1465CB7B3761}"/>
              </a:ext>
            </a:extLst>
          </p:cNvPr>
          <p:cNvSpPr txBox="1"/>
          <p:nvPr/>
        </p:nvSpPr>
        <p:spPr>
          <a:xfrm rot="5400000">
            <a:off x="771101" y="5054120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8D14D5C2-3CCB-CA47-7D7D-5F082F2EEA83}"/>
              </a:ext>
            </a:extLst>
          </p:cNvPr>
          <p:cNvCxnSpPr>
            <a:cxnSpLocks/>
          </p:cNvCxnSpPr>
          <p:nvPr/>
        </p:nvCxnSpPr>
        <p:spPr>
          <a:xfrm>
            <a:off x="1067424" y="495848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E711D903-122C-50CC-7AD5-D9669B267929}"/>
              </a:ext>
            </a:extLst>
          </p:cNvPr>
          <p:cNvSpPr txBox="1"/>
          <p:nvPr/>
        </p:nvSpPr>
        <p:spPr>
          <a:xfrm rot="5400000">
            <a:off x="887881" y="5043945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30A9145B-077D-D22C-4960-FB8A45D055F2}"/>
              </a:ext>
            </a:extLst>
          </p:cNvPr>
          <p:cNvSpPr txBox="1"/>
          <p:nvPr/>
        </p:nvSpPr>
        <p:spPr>
          <a:xfrm rot="18581330">
            <a:off x="875743" y="4660120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BA035624-79FE-C1D1-4107-AE9E41E50216}"/>
              </a:ext>
            </a:extLst>
          </p:cNvPr>
          <p:cNvSpPr txBox="1"/>
          <p:nvPr/>
        </p:nvSpPr>
        <p:spPr>
          <a:xfrm rot="18391185">
            <a:off x="658438" y="4645912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8FA68182-3364-7A6D-8E3A-DDD5A7B23905}"/>
              </a:ext>
            </a:extLst>
          </p:cNvPr>
          <p:cNvSpPr txBox="1"/>
          <p:nvPr/>
        </p:nvSpPr>
        <p:spPr>
          <a:xfrm rot="5400000">
            <a:off x="5381706" y="5176571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6A5942B9-CDA8-6865-A9F6-352D01420119}"/>
              </a:ext>
            </a:extLst>
          </p:cNvPr>
          <p:cNvCxnSpPr>
            <a:cxnSpLocks/>
          </p:cNvCxnSpPr>
          <p:nvPr/>
        </p:nvCxnSpPr>
        <p:spPr>
          <a:xfrm>
            <a:off x="5693929" y="507298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9A38882D-01CE-18EE-A985-8EF087FFD8A4}"/>
              </a:ext>
            </a:extLst>
          </p:cNvPr>
          <p:cNvSpPr txBox="1"/>
          <p:nvPr/>
        </p:nvSpPr>
        <p:spPr>
          <a:xfrm rot="5400000">
            <a:off x="5522337" y="5166396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B7448E08-5446-F2D2-FF0C-5C7F762C7F58}"/>
              </a:ext>
            </a:extLst>
          </p:cNvPr>
          <p:cNvSpPr txBox="1"/>
          <p:nvPr/>
        </p:nvSpPr>
        <p:spPr>
          <a:xfrm rot="5400000">
            <a:off x="5653373" y="5177902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5D33E372-4BD9-5C44-3D3D-4445BB97FCE6}"/>
              </a:ext>
            </a:extLst>
          </p:cNvPr>
          <p:cNvCxnSpPr>
            <a:cxnSpLocks/>
          </p:cNvCxnSpPr>
          <p:nvPr/>
        </p:nvCxnSpPr>
        <p:spPr>
          <a:xfrm>
            <a:off x="5949696" y="507431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E35F1275-1148-4AC7-6FF8-AB7BBEFF4AEF}"/>
              </a:ext>
            </a:extLst>
          </p:cNvPr>
          <p:cNvSpPr txBox="1"/>
          <p:nvPr/>
        </p:nvSpPr>
        <p:spPr>
          <a:xfrm rot="5400000">
            <a:off x="5786055" y="5167727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2E4D3351-77F3-C548-0E4B-F2DAB9D54FA1}"/>
              </a:ext>
            </a:extLst>
          </p:cNvPr>
          <p:cNvSpPr txBox="1"/>
          <p:nvPr/>
        </p:nvSpPr>
        <p:spPr>
          <a:xfrm rot="18581330">
            <a:off x="5738965" y="4763251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D0C3F738-2AD2-FA18-F79B-FA3E0A4A954F}"/>
              </a:ext>
            </a:extLst>
          </p:cNvPr>
          <p:cNvSpPr txBox="1"/>
          <p:nvPr/>
        </p:nvSpPr>
        <p:spPr>
          <a:xfrm rot="18391185">
            <a:off x="5521660" y="4749043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8CF543BC-3B01-9BFA-3611-D322CBE0F66A}"/>
              </a:ext>
            </a:extLst>
          </p:cNvPr>
          <p:cNvSpPr txBox="1"/>
          <p:nvPr/>
        </p:nvSpPr>
        <p:spPr>
          <a:xfrm>
            <a:off x="3455646" y="508425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AE234FD-FD6E-ABF4-652B-508C10B8FEC6}"/>
              </a:ext>
            </a:extLst>
          </p:cNvPr>
          <p:cNvSpPr txBox="1"/>
          <p:nvPr/>
        </p:nvSpPr>
        <p:spPr>
          <a:xfrm>
            <a:off x="3545279" y="5290786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EC8E3C90-B3F5-A868-0A7E-2A7295D93438}"/>
              </a:ext>
            </a:extLst>
          </p:cNvPr>
          <p:cNvSpPr txBox="1"/>
          <p:nvPr/>
        </p:nvSpPr>
        <p:spPr>
          <a:xfrm>
            <a:off x="3555909" y="5409999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C6B621F-1951-0CDB-6470-F29435FE5CEA}"/>
              </a:ext>
            </a:extLst>
          </p:cNvPr>
          <p:cNvSpPr txBox="1"/>
          <p:nvPr/>
        </p:nvSpPr>
        <p:spPr>
          <a:xfrm rot="5400000">
            <a:off x="4054421" y="5044053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6DF0AFCD-792E-509E-BCC9-4BAB895A4EAF}"/>
              </a:ext>
            </a:extLst>
          </p:cNvPr>
          <p:cNvCxnSpPr>
            <a:cxnSpLocks/>
          </p:cNvCxnSpPr>
          <p:nvPr/>
        </p:nvCxnSpPr>
        <p:spPr>
          <a:xfrm>
            <a:off x="4350744" y="4940469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2605D4D-43BB-EFD3-1220-A753315F0EBC}"/>
              </a:ext>
            </a:extLst>
          </p:cNvPr>
          <p:cNvSpPr txBox="1"/>
          <p:nvPr/>
        </p:nvSpPr>
        <p:spPr>
          <a:xfrm rot="5400000">
            <a:off x="4187103" y="5033878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D9E618B5-B9F9-2DD8-C2F6-00D58BE3CDD7}"/>
              </a:ext>
            </a:extLst>
          </p:cNvPr>
          <p:cNvSpPr txBox="1"/>
          <p:nvPr/>
        </p:nvSpPr>
        <p:spPr>
          <a:xfrm rot="18581330">
            <a:off x="4140013" y="4629402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9090F3B-BE4D-6AE2-E17A-8787648BA9BE}"/>
              </a:ext>
            </a:extLst>
          </p:cNvPr>
          <p:cNvSpPr txBox="1"/>
          <p:nvPr/>
        </p:nvSpPr>
        <p:spPr>
          <a:xfrm>
            <a:off x="2135543" y="4315008"/>
            <a:ext cx="441357" cy="381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3367F06-4542-88C4-80CD-62842D21BE51}"/>
              </a:ext>
            </a:extLst>
          </p:cNvPr>
          <p:cNvSpPr txBox="1"/>
          <p:nvPr/>
        </p:nvSpPr>
        <p:spPr>
          <a:xfrm>
            <a:off x="127978" y="736330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4148B4C-802C-A4C5-3ADE-96237D6424D5}"/>
              </a:ext>
            </a:extLst>
          </p:cNvPr>
          <p:cNvSpPr txBox="1"/>
          <p:nvPr/>
        </p:nvSpPr>
        <p:spPr>
          <a:xfrm>
            <a:off x="204857" y="7574691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A0B8AE5-5F46-5E0D-87A8-F97FE4F85672}"/>
              </a:ext>
            </a:extLst>
          </p:cNvPr>
          <p:cNvSpPr txBox="1"/>
          <p:nvPr/>
        </p:nvSpPr>
        <p:spPr>
          <a:xfrm>
            <a:off x="207536" y="7677952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04E77FC-F141-0A68-7A25-51499673DBE8}"/>
              </a:ext>
            </a:extLst>
          </p:cNvPr>
          <p:cNvSpPr txBox="1"/>
          <p:nvPr/>
        </p:nvSpPr>
        <p:spPr>
          <a:xfrm rot="5400000">
            <a:off x="466996" y="7432719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6921EDE9-1536-E322-E151-E867B15FA1D3}"/>
              </a:ext>
            </a:extLst>
          </p:cNvPr>
          <p:cNvCxnSpPr>
            <a:cxnSpLocks/>
          </p:cNvCxnSpPr>
          <p:nvPr/>
        </p:nvCxnSpPr>
        <p:spPr>
          <a:xfrm>
            <a:off x="763318" y="732118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8D3BB164-410A-BE99-15E9-D429EEE48423}"/>
              </a:ext>
            </a:extLst>
          </p:cNvPr>
          <p:cNvSpPr txBox="1"/>
          <p:nvPr/>
        </p:nvSpPr>
        <p:spPr>
          <a:xfrm rot="5400000">
            <a:off x="591726" y="7406644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B8309762-69B9-2638-EED4-975C0BC0E050}"/>
              </a:ext>
            </a:extLst>
          </p:cNvPr>
          <p:cNvSpPr txBox="1"/>
          <p:nvPr/>
        </p:nvSpPr>
        <p:spPr>
          <a:xfrm rot="5400000">
            <a:off x="722307" y="7434052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1" name="直線コネクタ 230">
            <a:extLst>
              <a:ext uri="{FF2B5EF4-FFF2-40B4-BE49-F238E27FC236}">
                <a16:creationId xmlns:a16="http://schemas.microsoft.com/office/drawing/2014/main" id="{84F9457C-7A53-BEA3-66CF-9CAE2071799C}"/>
              </a:ext>
            </a:extLst>
          </p:cNvPr>
          <p:cNvCxnSpPr>
            <a:cxnSpLocks/>
          </p:cNvCxnSpPr>
          <p:nvPr/>
        </p:nvCxnSpPr>
        <p:spPr>
          <a:xfrm>
            <a:off x="1026581" y="732251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061B8502-81E8-8832-309A-3CF0A509ACB7}"/>
              </a:ext>
            </a:extLst>
          </p:cNvPr>
          <p:cNvSpPr txBox="1"/>
          <p:nvPr/>
        </p:nvSpPr>
        <p:spPr>
          <a:xfrm rot="5400000">
            <a:off x="854989" y="7415926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44964A18-6496-C1BF-C6B0-039DD0614BDC}"/>
              </a:ext>
            </a:extLst>
          </p:cNvPr>
          <p:cNvSpPr txBox="1"/>
          <p:nvPr/>
        </p:nvSpPr>
        <p:spPr>
          <a:xfrm rot="18581330">
            <a:off x="808354" y="6997095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F4953F98-E6E4-24D0-A5CB-0225E07B64E4}"/>
              </a:ext>
            </a:extLst>
          </p:cNvPr>
          <p:cNvSpPr txBox="1"/>
          <p:nvPr/>
        </p:nvSpPr>
        <p:spPr>
          <a:xfrm rot="18391185">
            <a:off x="591049" y="6982887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2A8ED6D3-8278-F87C-F49F-FE0A4783F861}"/>
              </a:ext>
            </a:extLst>
          </p:cNvPr>
          <p:cNvSpPr/>
          <p:nvPr/>
        </p:nvSpPr>
        <p:spPr>
          <a:xfrm>
            <a:off x="2400135" y="5295571"/>
            <a:ext cx="288000" cy="144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30EDBC7-FDA1-324D-31AD-46D8368C85C8}"/>
              </a:ext>
            </a:extLst>
          </p:cNvPr>
          <p:cNvSpPr txBox="1"/>
          <p:nvPr/>
        </p:nvSpPr>
        <p:spPr>
          <a:xfrm>
            <a:off x="1813441" y="507960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7F6D0E8-45CC-6407-361D-D07A7094FB2B}"/>
              </a:ext>
            </a:extLst>
          </p:cNvPr>
          <p:cNvSpPr txBox="1"/>
          <p:nvPr/>
        </p:nvSpPr>
        <p:spPr>
          <a:xfrm>
            <a:off x="1879221" y="5286127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67409EC-A953-1C4D-2DCF-28CB88D83191}"/>
              </a:ext>
            </a:extLst>
          </p:cNvPr>
          <p:cNvSpPr txBox="1"/>
          <p:nvPr/>
        </p:nvSpPr>
        <p:spPr>
          <a:xfrm>
            <a:off x="1873949" y="5405340"/>
            <a:ext cx="792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7 </a:t>
            </a:r>
            <a:r>
              <a:rPr kumimoji="1" lang="en-US" altLang="ja-JP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9ECB496-CCB6-6E00-6988-5ABB7E02059C}"/>
              </a:ext>
            </a:extLst>
          </p:cNvPr>
          <p:cNvSpPr txBox="1"/>
          <p:nvPr/>
        </p:nvSpPr>
        <p:spPr>
          <a:xfrm rot="5400000">
            <a:off x="2148499" y="5014210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8F8FD027-58DE-AB97-7C10-A88C571D585E}"/>
              </a:ext>
            </a:extLst>
          </p:cNvPr>
          <p:cNvCxnSpPr>
            <a:cxnSpLocks/>
          </p:cNvCxnSpPr>
          <p:nvPr/>
        </p:nvCxnSpPr>
        <p:spPr>
          <a:xfrm>
            <a:off x="2452771" y="491062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DDD4B7C-4E6C-0854-6E84-8EA387FA99A6}"/>
              </a:ext>
            </a:extLst>
          </p:cNvPr>
          <p:cNvSpPr txBox="1"/>
          <p:nvPr/>
        </p:nvSpPr>
        <p:spPr>
          <a:xfrm rot="5400000">
            <a:off x="2289130" y="5004035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as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AFFC236-C6E5-6F6D-C024-8235F058B01C}"/>
              </a:ext>
            </a:extLst>
          </p:cNvPr>
          <p:cNvSpPr txBox="1"/>
          <p:nvPr/>
        </p:nvSpPr>
        <p:spPr>
          <a:xfrm rot="18391185">
            <a:off x="2328208" y="4586682"/>
            <a:ext cx="684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E2056FA7-0A0A-8E1F-990C-EB6BF4B19649}"/>
              </a:ext>
            </a:extLst>
          </p:cNvPr>
          <p:cNvSpPr/>
          <p:nvPr/>
        </p:nvSpPr>
        <p:spPr>
          <a:xfrm>
            <a:off x="4309313" y="5302879"/>
            <a:ext cx="288000" cy="144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77AB2B26-BE7D-4EF1-EB70-6551058EAEFC}"/>
              </a:ext>
            </a:extLst>
          </p:cNvPr>
          <p:cNvSpPr/>
          <p:nvPr/>
        </p:nvSpPr>
        <p:spPr>
          <a:xfrm>
            <a:off x="781461" y="5301963"/>
            <a:ext cx="252000" cy="126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0CDF5DA-E223-0263-322B-DD9F460BAE54}"/>
              </a:ext>
            </a:extLst>
          </p:cNvPr>
          <p:cNvSpPr/>
          <p:nvPr/>
        </p:nvSpPr>
        <p:spPr>
          <a:xfrm>
            <a:off x="1035769" y="5299314"/>
            <a:ext cx="252000" cy="126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8809A19F-0813-67EA-E4EB-7FD790E470A7}"/>
              </a:ext>
            </a:extLst>
          </p:cNvPr>
          <p:cNvSpPr/>
          <p:nvPr/>
        </p:nvSpPr>
        <p:spPr>
          <a:xfrm>
            <a:off x="5624459" y="5440140"/>
            <a:ext cx="288000" cy="144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5E65FE8-27DB-37FD-FA3B-2D1163FFBC58}"/>
              </a:ext>
            </a:extLst>
          </p:cNvPr>
          <p:cNvSpPr/>
          <p:nvPr/>
        </p:nvSpPr>
        <p:spPr>
          <a:xfrm>
            <a:off x="5913108" y="5438121"/>
            <a:ext cx="288000" cy="144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894F94E7-9B6F-4CAB-6442-0BC906D5F314}"/>
              </a:ext>
            </a:extLst>
          </p:cNvPr>
          <p:cNvSpPr/>
          <p:nvPr/>
        </p:nvSpPr>
        <p:spPr>
          <a:xfrm>
            <a:off x="717908" y="7703152"/>
            <a:ext cx="288000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DA5F3DB-5D8F-EB1F-1B8A-9BF70C296FF5}"/>
              </a:ext>
            </a:extLst>
          </p:cNvPr>
          <p:cNvSpPr/>
          <p:nvPr/>
        </p:nvSpPr>
        <p:spPr>
          <a:xfrm>
            <a:off x="1006557" y="7701133"/>
            <a:ext cx="288000" cy="108000"/>
          </a:xfrm>
          <a:prstGeom prst="rect">
            <a:avLst/>
          </a:prstGeom>
          <a:noFill/>
          <a:ln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図 39">
            <a:extLst>
              <a:ext uri="{FF2B5EF4-FFF2-40B4-BE49-F238E27FC236}">
                <a16:creationId xmlns:a16="http://schemas.microsoft.com/office/drawing/2014/main" id="{468B85CF-DAB2-F073-CA0C-3E10E63D45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16074" y="1010352"/>
            <a:ext cx="2341067" cy="2877561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28652F7D-41D6-96FD-0F07-76ADA2E5498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91459" y="1010349"/>
            <a:ext cx="2341067" cy="2877561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F238FA69-A389-3C8F-22EC-FFD926759F8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0" y="949097"/>
            <a:ext cx="2341067" cy="295072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F4F0DBE1-85D8-022D-6C4D-98BE1CD53D1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46790" y="1006146"/>
            <a:ext cx="2341067" cy="2883658"/>
          </a:xfrm>
          <a:prstGeom prst="rect">
            <a:avLst/>
          </a:prstGeom>
        </p:spPr>
      </p:pic>
      <p:sp>
        <p:nvSpPr>
          <p:cNvPr id="2050" name="テキスト ボックス 2049">
            <a:extLst>
              <a:ext uri="{FF2B5EF4-FFF2-40B4-BE49-F238E27FC236}">
                <a16:creationId xmlns:a16="http://schemas.microsoft.com/office/drawing/2014/main" id="{178631B3-93A8-0F27-5016-ABDAD5472D99}"/>
              </a:ext>
            </a:extLst>
          </p:cNvPr>
          <p:cNvSpPr txBox="1"/>
          <p:nvPr/>
        </p:nvSpPr>
        <p:spPr>
          <a:xfrm>
            <a:off x="1043782" y="829976"/>
            <a:ext cx="867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ANC-1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3" name="テキスト ボックス 2052">
            <a:extLst>
              <a:ext uri="{FF2B5EF4-FFF2-40B4-BE49-F238E27FC236}">
                <a16:creationId xmlns:a16="http://schemas.microsoft.com/office/drawing/2014/main" id="{26BA6CD2-6403-B200-5523-0D712ABC6E17}"/>
              </a:ext>
            </a:extLst>
          </p:cNvPr>
          <p:cNvSpPr txBox="1"/>
          <p:nvPr/>
        </p:nvSpPr>
        <p:spPr>
          <a:xfrm>
            <a:off x="2742301" y="829976"/>
            <a:ext cx="1023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A PaCa-2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4" name="テキスト ボックス 2053">
            <a:extLst>
              <a:ext uri="{FF2B5EF4-FFF2-40B4-BE49-F238E27FC236}">
                <a16:creationId xmlns:a16="http://schemas.microsoft.com/office/drawing/2014/main" id="{01083313-4D46-F850-3DEF-079C9214C4FB}"/>
              </a:ext>
            </a:extLst>
          </p:cNvPr>
          <p:cNvSpPr txBox="1"/>
          <p:nvPr/>
        </p:nvSpPr>
        <p:spPr>
          <a:xfrm>
            <a:off x="4464568" y="829976"/>
            <a:ext cx="1023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SN-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5" name="テキスト ボックス 2054">
            <a:extLst>
              <a:ext uri="{FF2B5EF4-FFF2-40B4-BE49-F238E27FC236}">
                <a16:creationId xmlns:a16="http://schemas.microsoft.com/office/drawing/2014/main" id="{B85C3510-FED3-111D-EBA9-58E05C212118}"/>
              </a:ext>
            </a:extLst>
          </p:cNvPr>
          <p:cNvSpPr txBox="1"/>
          <p:nvPr/>
        </p:nvSpPr>
        <p:spPr>
          <a:xfrm>
            <a:off x="6195089" y="829977"/>
            <a:ext cx="1023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2-0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6" name="テキスト ボックス 2055">
            <a:extLst>
              <a:ext uri="{FF2B5EF4-FFF2-40B4-BE49-F238E27FC236}">
                <a16:creationId xmlns:a16="http://schemas.microsoft.com/office/drawing/2014/main" id="{796C6207-E1F0-6BDE-2055-CEF9117338FE}"/>
              </a:ext>
            </a:extLst>
          </p:cNvPr>
          <p:cNvSpPr txBox="1"/>
          <p:nvPr/>
        </p:nvSpPr>
        <p:spPr>
          <a:xfrm>
            <a:off x="141501" y="708648"/>
            <a:ext cx="41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E01F53B-88C2-8389-C73D-D113359C2563}"/>
              </a:ext>
            </a:extLst>
          </p:cNvPr>
          <p:cNvSpPr txBox="1"/>
          <p:nvPr/>
        </p:nvSpPr>
        <p:spPr>
          <a:xfrm>
            <a:off x="6551873" y="-850226"/>
            <a:ext cx="914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2579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990</TotalTime>
  <Words>1044</Words>
  <Application>Microsoft Office PowerPoint</Application>
  <PresentationFormat>Custom</PresentationFormat>
  <Paragraphs>31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洋利 持田</dc:creator>
  <cp:lastModifiedBy>MDPI</cp:lastModifiedBy>
  <cp:revision>73</cp:revision>
  <cp:lastPrinted>2026-04-30T22:03:48Z</cp:lastPrinted>
  <dcterms:created xsi:type="dcterms:W3CDTF">2025-01-02T10:23:22Z</dcterms:created>
  <dcterms:modified xsi:type="dcterms:W3CDTF">2026-06-01T09:00:44Z</dcterms:modified>
</cp:coreProperties>
</file>